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3"/>
  </p:notesMasterIdLst>
  <p:sldIdLst>
    <p:sldId id="256" r:id="rId2"/>
  </p:sldIdLst>
  <p:sldSz cx="8686800" cy="3200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330" autoAdjust="0"/>
    <p:restoredTop sz="94660"/>
  </p:normalViewPr>
  <p:slideViewPr>
    <p:cSldViewPr snapToGrid="0">
      <p:cViewPr varScale="1">
        <p:scale>
          <a:sx n="134" d="100"/>
          <a:sy n="134" d="100"/>
        </p:scale>
        <p:origin x="84" y="495"/>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ohiuddin, Sayed Golam" userId="5c5f2d06-5da7-4463-8de7-92cf1264e307" providerId="ADAL" clId="{A3AEDC5A-5245-4379-A9AB-5C55CA29DAF3}"/>
    <pc:docChg chg="modSld">
      <pc:chgData name="Mohiuddin, Sayed Golam" userId="5c5f2d06-5da7-4463-8de7-92cf1264e307" providerId="ADAL" clId="{A3AEDC5A-5245-4379-A9AB-5C55CA29DAF3}" dt="2023-08-03T22:21:54.300" v="47" actId="1076"/>
      <pc:docMkLst>
        <pc:docMk/>
      </pc:docMkLst>
      <pc:sldChg chg="addSp modSp mod">
        <pc:chgData name="Mohiuddin, Sayed Golam" userId="5c5f2d06-5da7-4463-8de7-92cf1264e307" providerId="ADAL" clId="{A3AEDC5A-5245-4379-A9AB-5C55CA29DAF3}" dt="2023-08-03T22:21:54.300" v="47" actId="1076"/>
        <pc:sldMkLst>
          <pc:docMk/>
          <pc:sldMk cId="1393370754" sldId="256"/>
        </pc:sldMkLst>
        <pc:spChg chg="mod">
          <ac:chgData name="Mohiuddin, Sayed Golam" userId="5c5f2d06-5da7-4463-8de7-92cf1264e307" providerId="ADAL" clId="{A3AEDC5A-5245-4379-A9AB-5C55CA29DAF3}" dt="2023-08-03T22:21:11.794" v="37" actId="1035"/>
          <ac:spMkLst>
            <pc:docMk/>
            <pc:sldMk cId="1393370754" sldId="256"/>
            <ac:spMk id="5" creationId="{B53EE3D0-5CBC-1FA0-ADC7-F95A8E4E9370}"/>
          </ac:spMkLst>
        </pc:spChg>
        <pc:spChg chg="mod">
          <ac:chgData name="Mohiuddin, Sayed Golam" userId="5c5f2d06-5da7-4463-8de7-92cf1264e307" providerId="ADAL" clId="{A3AEDC5A-5245-4379-A9AB-5C55CA29DAF3}" dt="2023-08-03T22:21:11.794" v="37" actId="1035"/>
          <ac:spMkLst>
            <pc:docMk/>
            <pc:sldMk cId="1393370754" sldId="256"/>
            <ac:spMk id="6" creationId="{33167FC3-E2DF-891E-1CE2-A48D2BEEA344}"/>
          </ac:spMkLst>
        </pc:spChg>
        <pc:spChg chg="mod">
          <ac:chgData name="Mohiuddin, Sayed Golam" userId="5c5f2d06-5da7-4463-8de7-92cf1264e307" providerId="ADAL" clId="{A3AEDC5A-5245-4379-A9AB-5C55CA29DAF3}" dt="2023-08-03T22:21:11.794" v="37" actId="1035"/>
          <ac:spMkLst>
            <pc:docMk/>
            <pc:sldMk cId="1393370754" sldId="256"/>
            <ac:spMk id="8" creationId="{A2AB9AF4-4CF0-F52D-F24A-935E87896A87}"/>
          </ac:spMkLst>
        </pc:spChg>
        <pc:spChg chg="mod">
          <ac:chgData name="Mohiuddin, Sayed Golam" userId="5c5f2d06-5da7-4463-8de7-92cf1264e307" providerId="ADAL" clId="{A3AEDC5A-5245-4379-A9AB-5C55CA29DAF3}" dt="2023-08-03T22:21:11.794" v="37" actId="1035"/>
          <ac:spMkLst>
            <pc:docMk/>
            <pc:sldMk cId="1393370754" sldId="256"/>
            <ac:spMk id="9" creationId="{5A38D8DF-4886-F41F-9508-079A964E18E8}"/>
          </ac:spMkLst>
        </pc:spChg>
        <pc:spChg chg="mod">
          <ac:chgData name="Mohiuddin, Sayed Golam" userId="5c5f2d06-5da7-4463-8de7-92cf1264e307" providerId="ADAL" clId="{A3AEDC5A-5245-4379-A9AB-5C55CA29DAF3}" dt="2023-08-03T22:21:11.794" v="37" actId="1035"/>
          <ac:spMkLst>
            <pc:docMk/>
            <pc:sldMk cId="1393370754" sldId="256"/>
            <ac:spMk id="11" creationId="{A088BA6D-BD61-F58B-7145-66A3E752AF88}"/>
          </ac:spMkLst>
        </pc:spChg>
        <pc:spChg chg="mod">
          <ac:chgData name="Mohiuddin, Sayed Golam" userId="5c5f2d06-5da7-4463-8de7-92cf1264e307" providerId="ADAL" clId="{A3AEDC5A-5245-4379-A9AB-5C55CA29DAF3}" dt="2023-08-03T22:21:11.794" v="37" actId="1035"/>
          <ac:spMkLst>
            <pc:docMk/>
            <pc:sldMk cId="1393370754" sldId="256"/>
            <ac:spMk id="15" creationId="{8A011965-3377-FB1F-F002-23F93DC52C0D}"/>
          </ac:spMkLst>
        </pc:spChg>
        <pc:spChg chg="mod">
          <ac:chgData name="Mohiuddin, Sayed Golam" userId="5c5f2d06-5da7-4463-8de7-92cf1264e307" providerId="ADAL" clId="{A3AEDC5A-5245-4379-A9AB-5C55CA29DAF3}" dt="2023-08-03T22:21:11.794" v="37" actId="1035"/>
          <ac:spMkLst>
            <pc:docMk/>
            <pc:sldMk cId="1393370754" sldId="256"/>
            <ac:spMk id="18" creationId="{54F79D6A-9543-7633-1A2F-FA8CC1FF2627}"/>
          </ac:spMkLst>
        </pc:spChg>
        <pc:spChg chg="mod">
          <ac:chgData name="Mohiuddin, Sayed Golam" userId="5c5f2d06-5da7-4463-8de7-92cf1264e307" providerId="ADAL" clId="{A3AEDC5A-5245-4379-A9AB-5C55CA29DAF3}" dt="2023-08-03T22:21:11.794" v="37" actId="1035"/>
          <ac:spMkLst>
            <pc:docMk/>
            <pc:sldMk cId="1393370754" sldId="256"/>
            <ac:spMk id="19" creationId="{97BE781C-A6AA-D27A-94C0-B6B3DD05F4B0}"/>
          </ac:spMkLst>
        </pc:spChg>
        <pc:spChg chg="add mod">
          <ac:chgData name="Mohiuddin, Sayed Golam" userId="5c5f2d06-5da7-4463-8de7-92cf1264e307" providerId="ADAL" clId="{A3AEDC5A-5245-4379-A9AB-5C55CA29DAF3}" dt="2023-08-03T22:21:54.300" v="47" actId="1076"/>
          <ac:spMkLst>
            <pc:docMk/>
            <pc:sldMk cId="1393370754" sldId="256"/>
            <ac:spMk id="20" creationId="{A5021E5F-A272-4724-B0D9-020635FD43C2}"/>
          </ac:spMkLst>
        </pc:spChg>
        <pc:spChg chg="mod">
          <ac:chgData name="Mohiuddin, Sayed Golam" userId="5c5f2d06-5da7-4463-8de7-92cf1264e307" providerId="ADAL" clId="{A3AEDC5A-5245-4379-A9AB-5C55CA29DAF3}" dt="2023-08-03T22:21:11.794" v="37" actId="1035"/>
          <ac:spMkLst>
            <pc:docMk/>
            <pc:sldMk cId="1393370754" sldId="256"/>
            <ac:spMk id="24" creationId="{10E43F29-9FD7-6734-C059-5CE8B0B9116A}"/>
          </ac:spMkLst>
        </pc:spChg>
        <pc:spChg chg="mod">
          <ac:chgData name="Mohiuddin, Sayed Golam" userId="5c5f2d06-5da7-4463-8de7-92cf1264e307" providerId="ADAL" clId="{A3AEDC5A-5245-4379-A9AB-5C55CA29DAF3}" dt="2023-08-03T22:21:11.794" v="37" actId="1035"/>
          <ac:spMkLst>
            <pc:docMk/>
            <pc:sldMk cId="1393370754" sldId="256"/>
            <ac:spMk id="25" creationId="{C98FED20-F014-53D2-A1D1-E55AF7A2EEBD}"/>
          </ac:spMkLst>
        </pc:spChg>
        <pc:spChg chg="mod">
          <ac:chgData name="Mohiuddin, Sayed Golam" userId="5c5f2d06-5da7-4463-8de7-92cf1264e307" providerId="ADAL" clId="{A3AEDC5A-5245-4379-A9AB-5C55CA29DAF3}" dt="2023-08-03T22:21:11.794" v="37" actId="1035"/>
          <ac:spMkLst>
            <pc:docMk/>
            <pc:sldMk cId="1393370754" sldId="256"/>
            <ac:spMk id="26" creationId="{41D30EA0-AE3C-CBD7-2B61-FE1AE6E65B32}"/>
          </ac:spMkLst>
        </pc:spChg>
        <pc:spChg chg="mod">
          <ac:chgData name="Mohiuddin, Sayed Golam" userId="5c5f2d06-5da7-4463-8de7-92cf1264e307" providerId="ADAL" clId="{A3AEDC5A-5245-4379-A9AB-5C55CA29DAF3}" dt="2023-08-03T22:21:11.794" v="37" actId="1035"/>
          <ac:spMkLst>
            <pc:docMk/>
            <pc:sldMk cId="1393370754" sldId="256"/>
            <ac:spMk id="27" creationId="{F90EE355-8D05-F964-B9D8-10B1FD6D4774}"/>
          </ac:spMkLst>
        </pc:spChg>
        <pc:picChg chg="mod">
          <ac:chgData name="Mohiuddin, Sayed Golam" userId="5c5f2d06-5da7-4463-8de7-92cf1264e307" providerId="ADAL" clId="{A3AEDC5A-5245-4379-A9AB-5C55CA29DAF3}" dt="2023-08-03T22:21:11.794" v="37" actId="1035"/>
          <ac:picMkLst>
            <pc:docMk/>
            <pc:sldMk cId="1393370754" sldId="256"/>
            <ac:picMk id="4" creationId="{AD16E06E-0BB9-304C-70FB-B5349DD5DB7A}"/>
          </ac:picMkLst>
        </pc:picChg>
        <pc:picChg chg="mod">
          <ac:chgData name="Mohiuddin, Sayed Golam" userId="5c5f2d06-5da7-4463-8de7-92cf1264e307" providerId="ADAL" clId="{A3AEDC5A-5245-4379-A9AB-5C55CA29DAF3}" dt="2023-08-03T22:21:11.794" v="37" actId="1035"/>
          <ac:picMkLst>
            <pc:docMk/>
            <pc:sldMk cId="1393370754" sldId="256"/>
            <ac:picMk id="7" creationId="{E76DD2E3-070C-BA2D-DAA0-AF0F7E2DBB63}"/>
          </ac:picMkLst>
        </pc:picChg>
        <pc:picChg chg="mod">
          <ac:chgData name="Mohiuddin, Sayed Golam" userId="5c5f2d06-5da7-4463-8de7-92cf1264e307" providerId="ADAL" clId="{A3AEDC5A-5245-4379-A9AB-5C55CA29DAF3}" dt="2023-08-03T22:21:11.794" v="37" actId="1035"/>
          <ac:picMkLst>
            <pc:docMk/>
            <pc:sldMk cId="1393370754" sldId="256"/>
            <ac:picMk id="10" creationId="{AE2F676E-9301-2879-17E5-DBF535E48A06}"/>
          </ac:picMkLst>
        </pc:picChg>
        <pc:picChg chg="mod">
          <ac:chgData name="Mohiuddin, Sayed Golam" userId="5c5f2d06-5da7-4463-8de7-92cf1264e307" providerId="ADAL" clId="{A3AEDC5A-5245-4379-A9AB-5C55CA29DAF3}" dt="2023-08-03T22:21:11.794" v="37" actId="1035"/>
          <ac:picMkLst>
            <pc:docMk/>
            <pc:sldMk cId="1393370754" sldId="256"/>
            <ac:picMk id="16" creationId="{78424A46-F04A-DF78-5C3D-E727AA81880D}"/>
          </ac:picMkLst>
        </pc:picChg>
      </pc:sldChg>
    </pc:docChg>
  </pc:docChgLst>
  <pc:docChgLst>
    <pc:chgData name="Orman, Mehmet" userId="e05bb5d0-eb4a-4c62-ae3d-7ca463edc4b0" providerId="ADAL" clId="{EBAB199E-B95B-47C9-9EBC-3E9938862170}"/>
    <pc:docChg chg="modSld">
      <pc:chgData name="Orman, Mehmet" userId="e05bb5d0-eb4a-4c62-ae3d-7ca463edc4b0" providerId="ADAL" clId="{EBAB199E-B95B-47C9-9EBC-3E9938862170}" dt="2023-05-03T16:11:38.764" v="3" actId="1582"/>
      <pc:docMkLst>
        <pc:docMk/>
      </pc:docMkLst>
      <pc:sldChg chg="modSp mod">
        <pc:chgData name="Orman, Mehmet" userId="e05bb5d0-eb4a-4c62-ae3d-7ca463edc4b0" providerId="ADAL" clId="{EBAB199E-B95B-47C9-9EBC-3E9938862170}" dt="2023-05-03T16:11:38.764" v="3" actId="1582"/>
        <pc:sldMkLst>
          <pc:docMk/>
          <pc:sldMk cId="1393370754" sldId="256"/>
        </pc:sldMkLst>
        <pc:spChg chg="mod">
          <ac:chgData name="Orman, Mehmet" userId="e05bb5d0-eb4a-4c62-ae3d-7ca463edc4b0" providerId="ADAL" clId="{EBAB199E-B95B-47C9-9EBC-3E9938862170}" dt="2023-05-03T16:11:19.687" v="0" actId="1582"/>
          <ac:spMkLst>
            <pc:docMk/>
            <pc:sldMk cId="1393370754" sldId="256"/>
            <ac:spMk id="24" creationId="{10E43F29-9FD7-6734-C059-5CE8B0B9116A}"/>
          </ac:spMkLst>
        </pc:spChg>
        <pc:spChg chg="mod">
          <ac:chgData name="Orman, Mehmet" userId="e05bb5d0-eb4a-4c62-ae3d-7ca463edc4b0" providerId="ADAL" clId="{EBAB199E-B95B-47C9-9EBC-3E9938862170}" dt="2023-05-03T16:11:26.995" v="1" actId="1582"/>
          <ac:spMkLst>
            <pc:docMk/>
            <pc:sldMk cId="1393370754" sldId="256"/>
            <ac:spMk id="25" creationId="{C98FED20-F014-53D2-A1D1-E55AF7A2EEBD}"/>
          </ac:spMkLst>
        </pc:spChg>
        <pc:spChg chg="mod">
          <ac:chgData name="Orman, Mehmet" userId="e05bb5d0-eb4a-4c62-ae3d-7ca463edc4b0" providerId="ADAL" clId="{EBAB199E-B95B-47C9-9EBC-3E9938862170}" dt="2023-05-03T16:11:32.768" v="2" actId="1582"/>
          <ac:spMkLst>
            <pc:docMk/>
            <pc:sldMk cId="1393370754" sldId="256"/>
            <ac:spMk id="26" creationId="{41D30EA0-AE3C-CBD7-2B61-FE1AE6E65B32}"/>
          </ac:spMkLst>
        </pc:spChg>
        <pc:spChg chg="mod">
          <ac:chgData name="Orman, Mehmet" userId="e05bb5d0-eb4a-4c62-ae3d-7ca463edc4b0" providerId="ADAL" clId="{EBAB199E-B95B-47C9-9EBC-3E9938862170}" dt="2023-05-03T16:11:38.764" v="3" actId="1582"/>
          <ac:spMkLst>
            <pc:docMk/>
            <pc:sldMk cId="1393370754" sldId="256"/>
            <ac:spMk id="27" creationId="{F90EE355-8D05-F964-B9D8-10B1FD6D4774}"/>
          </ac:spMkLst>
        </pc:spChg>
      </pc:sldChg>
    </pc:docChg>
  </pc:docChgLst>
  <pc:docChgLst>
    <pc:chgData name="Dewangan, Narendra K" userId="d41fbbea-b8bc-4fa8-86f3-192c481edae6" providerId="ADAL" clId="{1497A3E2-B509-46DD-B1A1-05079E97B85D}"/>
    <pc:docChg chg="undo custSel modSld">
      <pc:chgData name="Dewangan, Narendra K" userId="d41fbbea-b8bc-4fa8-86f3-192c481edae6" providerId="ADAL" clId="{1497A3E2-B509-46DD-B1A1-05079E97B85D}" dt="2023-02-26T22:51:18.438" v="179" actId="20577"/>
      <pc:docMkLst>
        <pc:docMk/>
      </pc:docMkLst>
      <pc:sldChg chg="addSp delSp modSp mod addAnim delAnim">
        <pc:chgData name="Dewangan, Narendra K" userId="d41fbbea-b8bc-4fa8-86f3-192c481edae6" providerId="ADAL" clId="{1497A3E2-B509-46DD-B1A1-05079E97B85D}" dt="2023-02-26T22:51:18.438" v="179" actId="20577"/>
        <pc:sldMkLst>
          <pc:docMk/>
          <pc:sldMk cId="1393370754" sldId="256"/>
        </pc:sldMkLst>
        <pc:spChg chg="add del">
          <ac:chgData name="Dewangan, Narendra K" userId="d41fbbea-b8bc-4fa8-86f3-192c481edae6" providerId="ADAL" clId="{1497A3E2-B509-46DD-B1A1-05079E97B85D}" dt="2023-02-26T22:37:58.303" v="8" actId="11529"/>
          <ac:spMkLst>
            <pc:docMk/>
            <pc:sldMk cId="1393370754" sldId="256"/>
            <ac:spMk id="2" creationId="{A87CE345-E26F-4855-2312-C1F072AC7983}"/>
          </ac:spMkLst>
        </pc:spChg>
        <pc:spChg chg="add del">
          <ac:chgData name="Dewangan, Narendra K" userId="d41fbbea-b8bc-4fa8-86f3-192c481edae6" providerId="ADAL" clId="{1497A3E2-B509-46DD-B1A1-05079E97B85D}" dt="2023-02-26T22:42:04.320" v="22" actId="478"/>
          <ac:spMkLst>
            <pc:docMk/>
            <pc:sldMk cId="1393370754" sldId="256"/>
            <ac:spMk id="2" creationId="{AC4A6067-159D-93BF-B16E-110B1359F99B}"/>
          </ac:spMkLst>
        </pc:spChg>
        <pc:spChg chg="add del mod">
          <ac:chgData name="Dewangan, Narendra K" userId="d41fbbea-b8bc-4fa8-86f3-192c481edae6" providerId="ADAL" clId="{1497A3E2-B509-46DD-B1A1-05079E97B85D}" dt="2023-02-26T22:39:28.739" v="15" actId="478"/>
          <ac:spMkLst>
            <pc:docMk/>
            <pc:sldMk cId="1393370754" sldId="256"/>
            <ac:spMk id="3" creationId="{B917AB48-2B6B-DD3F-2A14-13A6CC0154D9}"/>
          </ac:spMkLst>
        </pc:spChg>
        <pc:spChg chg="add del mod">
          <ac:chgData name="Dewangan, Narendra K" userId="d41fbbea-b8bc-4fa8-86f3-192c481edae6" providerId="ADAL" clId="{1497A3E2-B509-46DD-B1A1-05079E97B85D}" dt="2023-02-26T22:44:28.242" v="32" actId="478"/>
          <ac:spMkLst>
            <pc:docMk/>
            <pc:sldMk cId="1393370754" sldId="256"/>
            <ac:spMk id="3" creationId="{EF8C409C-6358-E971-1B00-4EA0DD577A2E}"/>
          </ac:spMkLst>
        </pc:spChg>
        <pc:spChg chg="mod">
          <ac:chgData name="Dewangan, Narendra K" userId="d41fbbea-b8bc-4fa8-86f3-192c481edae6" providerId="ADAL" clId="{1497A3E2-B509-46DD-B1A1-05079E97B85D}" dt="2023-02-26T22:51:00.615" v="169" actId="20577"/>
          <ac:spMkLst>
            <pc:docMk/>
            <pc:sldMk cId="1393370754" sldId="256"/>
            <ac:spMk id="5" creationId="{B53EE3D0-5CBC-1FA0-ADC7-F95A8E4E9370}"/>
          </ac:spMkLst>
        </pc:spChg>
        <pc:spChg chg="mod">
          <ac:chgData name="Dewangan, Narendra K" userId="d41fbbea-b8bc-4fa8-86f3-192c481edae6" providerId="ADAL" clId="{1497A3E2-B509-46DD-B1A1-05079E97B85D}" dt="2023-02-26T22:51:18.438" v="179" actId="20577"/>
          <ac:spMkLst>
            <pc:docMk/>
            <pc:sldMk cId="1393370754" sldId="256"/>
            <ac:spMk id="9" creationId="{5A38D8DF-4886-F41F-9508-079A964E18E8}"/>
          </ac:spMkLst>
        </pc:spChg>
        <pc:spChg chg="add del mod">
          <ac:chgData name="Dewangan, Narendra K" userId="d41fbbea-b8bc-4fa8-86f3-192c481edae6" providerId="ADAL" clId="{1497A3E2-B509-46DD-B1A1-05079E97B85D}" dt="2023-02-26T22:49:02.012" v="74" actId="478"/>
          <ac:spMkLst>
            <pc:docMk/>
            <pc:sldMk cId="1393370754" sldId="256"/>
            <ac:spMk id="12" creationId="{301B4E84-BE06-9D43-BF5F-67F4BF1579F5}"/>
          </ac:spMkLst>
        </pc:spChg>
        <pc:spChg chg="del mod">
          <ac:chgData name="Dewangan, Narendra K" userId="d41fbbea-b8bc-4fa8-86f3-192c481edae6" providerId="ADAL" clId="{1497A3E2-B509-46DD-B1A1-05079E97B85D}" dt="2023-02-26T22:37:11.330" v="6" actId="478"/>
          <ac:spMkLst>
            <pc:docMk/>
            <pc:sldMk cId="1393370754" sldId="256"/>
            <ac:spMk id="12" creationId="{7BC91DAF-D055-672D-B7E8-01D0C56D8062}"/>
          </ac:spMkLst>
        </pc:spChg>
        <pc:spChg chg="del">
          <ac:chgData name="Dewangan, Narendra K" userId="d41fbbea-b8bc-4fa8-86f3-192c481edae6" providerId="ADAL" clId="{1497A3E2-B509-46DD-B1A1-05079E97B85D}" dt="2023-02-26T22:41:28.110" v="18" actId="478"/>
          <ac:spMkLst>
            <pc:docMk/>
            <pc:sldMk cId="1393370754" sldId="256"/>
            <ac:spMk id="13" creationId="{C0990A3B-F67B-EC3F-BE19-386EE2A92A49}"/>
          </ac:spMkLst>
        </pc:spChg>
        <pc:spChg chg="del">
          <ac:chgData name="Dewangan, Narendra K" userId="d41fbbea-b8bc-4fa8-86f3-192c481edae6" providerId="ADAL" clId="{1497A3E2-B509-46DD-B1A1-05079E97B85D}" dt="2023-02-26T22:41:30.581" v="19" actId="478"/>
          <ac:spMkLst>
            <pc:docMk/>
            <pc:sldMk cId="1393370754" sldId="256"/>
            <ac:spMk id="14" creationId="{43C289CB-7EE4-8156-B9DB-FBB4D6F4A75C}"/>
          </ac:spMkLst>
        </pc:spChg>
        <pc:spChg chg="del">
          <ac:chgData name="Dewangan, Narendra K" userId="d41fbbea-b8bc-4fa8-86f3-192c481edae6" providerId="ADAL" clId="{1497A3E2-B509-46DD-B1A1-05079E97B85D}" dt="2023-02-26T22:41:32.985" v="20" actId="478"/>
          <ac:spMkLst>
            <pc:docMk/>
            <pc:sldMk cId="1393370754" sldId="256"/>
            <ac:spMk id="17" creationId="{671B2DC2-2046-46EC-3ED2-EADFF581AC1B}"/>
          </ac:spMkLst>
        </pc:spChg>
        <pc:spChg chg="add del">
          <ac:chgData name="Dewangan, Narendra K" userId="d41fbbea-b8bc-4fa8-86f3-192c481edae6" providerId="ADAL" clId="{1497A3E2-B509-46DD-B1A1-05079E97B85D}" dt="2023-02-26T22:38:46.159" v="14" actId="478"/>
          <ac:spMkLst>
            <pc:docMk/>
            <pc:sldMk cId="1393370754" sldId="256"/>
            <ac:spMk id="20" creationId="{2E22E1A1-469F-08AE-2CB5-3C7C1868CB1E}"/>
          </ac:spMkLst>
        </pc:spChg>
        <pc:spChg chg="add del mod">
          <ac:chgData name="Dewangan, Narendra K" userId="d41fbbea-b8bc-4fa8-86f3-192c481edae6" providerId="ADAL" clId="{1497A3E2-B509-46DD-B1A1-05079E97B85D}" dt="2023-02-26T22:48:58.631" v="73" actId="478"/>
          <ac:spMkLst>
            <pc:docMk/>
            <pc:sldMk cId="1393370754" sldId="256"/>
            <ac:spMk id="20" creationId="{DC1CB63B-6FCA-8A07-1718-AC8819C13F79}"/>
          </ac:spMkLst>
        </pc:spChg>
        <pc:spChg chg="add del mod">
          <ac:chgData name="Dewangan, Narendra K" userId="d41fbbea-b8bc-4fa8-86f3-192c481edae6" providerId="ADAL" clId="{1497A3E2-B509-46DD-B1A1-05079E97B85D}" dt="2023-02-26T22:45:15.210" v="40" actId="11529"/>
          <ac:spMkLst>
            <pc:docMk/>
            <pc:sldMk cId="1393370754" sldId="256"/>
            <ac:spMk id="23" creationId="{324D0E0D-C123-C79D-90E7-D1B41D7C6CBE}"/>
          </ac:spMkLst>
        </pc:spChg>
        <pc:spChg chg="add mod">
          <ac:chgData name="Dewangan, Narendra K" userId="d41fbbea-b8bc-4fa8-86f3-192c481edae6" providerId="ADAL" clId="{1497A3E2-B509-46DD-B1A1-05079E97B85D}" dt="2023-02-26T22:49:13.486" v="77" actId="1076"/>
          <ac:spMkLst>
            <pc:docMk/>
            <pc:sldMk cId="1393370754" sldId="256"/>
            <ac:spMk id="24" creationId="{10E43F29-9FD7-6734-C059-5CE8B0B9116A}"/>
          </ac:spMkLst>
        </pc:spChg>
        <pc:spChg chg="add mod">
          <ac:chgData name="Dewangan, Narendra K" userId="d41fbbea-b8bc-4fa8-86f3-192c481edae6" providerId="ADAL" clId="{1497A3E2-B509-46DD-B1A1-05079E97B85D}" dt="2023-02-26T22:49:24.346" v="78" actId="1076"/>
          <ac:spMkLst>
            <pc:docMk/>
            <pc:sldMk cId="1393370754" sldId="256"/>
            <ac:spMk id="25" creationId="{C98FED20-F014-53D2-A1D1-E55AF7A2EEBD}"/>
          </ac:spMkLst>
        </pc:spChg>
        <pc:spChg chg="add mod">
          <ac:chgData name="Dewangan, Narendra K" userId="d41fbbea-b8bc-4fa8-86f3-192c481edae6" providerId="ADAL" clId="{1497A3E2-B509-46DD-B1A1-05079E97B85D}" dt="2023-02-26T22:49:44.452" v="99" actId="1037"/>
          <ac:spMkLst>
            <pc:docMk/>
            <pc:sldMk cId="1393370754" sldId="256"/>
            <ac:spMk id="26" creationId="{41D30EA0-AE3C-CBD7-2B61-FE1AE6E65B32}"/>
          </ac:spMkLst>
        </pc:spChg>
        <pc:spChg chg="add mod">
          <ac:chgData name="Dewangan, Narendra K" userId="d41fbbea-b8bc-4fa8-86f3-192c481edae6" providerId="ADAL" clId="{1497A3E2-B509-46DD-B1A1-05079E97B85D}" dt="2023-02-26T22:50:23.319" v="161" actId="1036"/>
          <ac:spMkLst>
            <pc:docMk/>
            <pc:sldMk cId="1393370754" sldId="256"/>
            <ac:spMk id="27" creationId="{F90EE355-8D05-F964-B9D8-10B1FD6D4774}"/>
          </ac:spMkLst>
        </pc:spChg>
        <pc:picChg chg="mod">
          <ac:chgData name="Dewangan, Narendra K" userId="d41fbbea-b8bc-4fa8-86f3-192c481edae6" providerId="ADAL" clId="{1497A3E2-B509-46DD-B1A1-05079E97B85D}" dt="2023-02-26T22:49:07.054" v="76" actId="1076"/>
          <ac:picMkLst>
            <pc:docMk/>
            <pc:sldMk cId="1393370754" sldId="256"/>
            <ac:picMk id="4" creationId="{AD16E06E-0BB9-304C-70FB-B5349DD5DB7A}"/>
          </ac:picMkLst>
        </pc:picChg>
        <pc:picChg chg="add del">
          <ac:chgData name="Dewangan, Narendra K" userId="d41fbbea-b8bc-4fa8-86f3-192c481edae6" providerId="ADAL" clId="{1497A3E2-B509-46DD-B1A1-05079E97B85D}" dt="2023-02-26T22:41:25.808" v="17" actId="478"/>
          <ac:picMkLst>
            <pc:docMk/>
            <pc:sldMk cId="1393370754" sldId="256"/>
            <ac:picMk id="7" creationId="{E76DD2E3-070C-BA2D-DAA0-AF0F7E2DBB63}"/>
          </ac:picMkLst>
        </pc:picChg>
        <pc:picChg chg="mod">
          <ac:chgData name="Dewangan, Narendra K" userId="d41fbbea-b8bc-4fa8-86f3-192c481edae6" providerId="ADAL" clId="{1497A3E2-B509-46DD-B1A1-05079E97B85D}" dt="2023-02-26T22:48:08.448" v="65" actId="1076"/>
          <ac:picMkLst>
            <pc:docMk/>
            <pc:sldMk cId="1393370754" sldId="256"/>
            <ac:picMk id="10" creationId="{AE2F676E-9301-2879-17E5-DBF535E48A06}"/>
          </ac:picMkLst>
        </pc:picChg>
        <pc:picChg chg="mod">
          <ac:chgData name="Dewangan, Narendra K" userId="d41fbbea-b8bc-4fa8-86f3-192c481edae6" providerId="ADAL" clId="{1497A3E2-B509-46DD-B1A1-05079E97B85D}" dt="2023-02-26T22:49:56.071" v="102" actId="1076"/>
          <ac:picMkLst>
            <pc:docMk/>
            <pc:sldMk cId="1393370754" sldId="256"/>
            <ac:picMk id="16" creationId="{78424A46-F04A-DF78-5C3D-E727AA81880D}"/>
          </ac:picMkLst>
        </pc:picChg>
        <pc:picChg chg="add del mod">
          <ac:chgData name="Dewangan, Narendra K" userId="d41fbbea-b8bc-4fa8-86f3-192c481edae6" providerId="ADAL" clId="{1497A3E2-B509-46DD-B1A1-05079E97B85D}" dt="2023-02-26T22:50:29.785" v="162" actId="478"/>
          <ac:picMkLst>
            <pc:docMk/>
            <pc:sldMk cId="1393370754" sldId="256"/>
            <ac:picMk id="22" creationId="{5EA4CE4A-A0A2-0283-4369-12197876E306}"/>
          </ac:picMkLst>
        </pc:picChg>
      </pc:sldChg>
    </pc:docChg>
  </pc:docChgLst>
  <pc:docChgLst>
    <pc:chgData name="Mohiuddin, Sayed Golam" userId="5c5f2d06-5da7-4463-8de7-92cf1264e307" providerId="ADAL" clId="{72DA5647-FC3B-4368-8059-A2DCD02654DF}"/>
    <pc:docChg chg="undo custSel addSld modSld">
      <pc:chgData name="Mohiuddin, Sayed Golam" userId="5c5f2d06-5da7-4463-8de7-92cf1264e307" providerId="ADAL" clId="{72DA5647-FC3B-4368-8059-A2DCD02654DF}" dt="2023-02-22T19:10:53.881" v="401" actId="1036"/>
      <pc:docMkLst>
        <pc:docMk/>
      </pc:docMkLst>
      <pc:sldChg chg="addSp delSp modSp new mod modAnim">
        <pc:chgData name="Mohiuddin, Sayed Golam" userId="5c5f2d06-5da7-4463-8de7-92cf1264e307" providerId="ADAL" clId="{72DA5647-FC3B-4368-8059-A2DCD02654DF}" dt="2023-02-22T19:10:53.881" v="401" actId="1036"/>
        <pc:sldMkLst>
          <pc:docMk/>
          <pc:sldMk cId="1393370754" sldId="256"/>
        </pc:sldMkLst>
        <pc:spChg chg="del">
          <ac:chgData name="Mohiuddin, Sayed Golam" userId="5c5f2d06-5da7-4463-8de7-92cf1264e307" providerId="ADAL" clId="{72DA5647-FC3B-4368-8059-A2DCD02654DF}" dt="2023-02-17T17:30:10.713" v="1" actId="478"/>
          <ac:spMkLst>
            <pc:docMk/>
            <pc:sldMk cId="1393370754" sldId="256"/>
            <ac:spMk id="2" creationId="{D5F2E37B-B436-A9C4-1076-8C872D4BB8A5}"/>
          </ac:spMkLst>
        </pc:spChg>
        <pc:spChg chg="del">
          <ac:chgData name="Mohiuddin, Sayed Golam" userId="5c5f2d06-5da7-4463-8de7-92cf1264e307" providerId="ADAL" clId="{72DA5647-FC3B-4368-8059-A2DCD02654DF}" dt="2023-02-17T17:30:10.713" v="1" actId="478"/>
          <ac:spMkLst>
            <pc:docMk/>
            <pc:sldMk cId="1393370754" sldId="256"/>
            <ac:spMk id="3" creationId="{01614047-9254-0CB5-D289-7CBD3B75C602}"/>
          </ac:spMkLst>
        </pc:spChg>
        <pc:spChg chg="add mod">
          <ac:chgData name="Mohiuddin, Sayed Golam" userId="5c5f2d06-5da7-4463-8de7-92cf1264e307" providerId="ADAL" clId="{72DA5647-FC3B-4368-8059-A2DCD02654DF}" dt="2023-02-22T19:10:43.920" v="394" actId="1036"/>
          <ac:spMkLst>
            <pc:docMk/>
            <pc:sldMk cId="1393370754" sldId="256"/>
            <ac:spMk id="5" creationId="{B53EE3D0-5CBC-1FA0-ADC7-F95A8E4E9370}"/>
          </ac:spMkLst>
        </pc:spChg>
        <pc:spChg chg="add mod">
          <ac:chgData name="Mohiuddin, Sayed Golam" userId="5c5f2d06-5da7-4463-8de7-92cf1264e307" providerId="ADAL" clId="{72DA5647-FC3B-4368-8059-A2DCD02654DF}" dt="2023-02-22T19:10:43.920" v="394" actId="1036"/>
          <ac:spMkLst>
            <pc:docMk/>
            <pc:sldMk cId="1393370754" sldId="256"/>
            <ac:spMk id="6" creationId="{33167FC3-E2DF-891E-1CE2-A48D2BEEA344}"/>
          </ac:spMkLst>
        </pc:spChg>
        <pc:spChg chg="add mod">
          <ac:chgData name="Mohiuddin, Sayed Golam" userId="5c5f2d06-5da7-4463-8de7-92cf1264e307" providerId="ADAL" clId="{72DA5647-FC3B-4368-8059-A2DCD02654DF}" dt="2023-02-22T19:10:43.920" v="394" actId="1036"/>
          <ac:spMkLst>
            <pc:docMk/>
            <pc:sldMk cId="1393370754" sldId="256"/>
            <ac:spMk id="8" creationId="{A2AB9AF4-4CF0-F52D-F24A-935E87896A87}"/>
          </ac:spMkLst>
        </pc:spChg>
        <pc:spChg chg="add mod">
          <ac:chgData name="Mohiuddin, Sayed Golam" userId="5c5f2d06-5da7-4463-8de7-92cf1264e307" providerId="ADAL" clId="{72DA5647-FC3B-4368-8059-A2DCD02654DF}" dt="2023-02-22T19:10:43.920" v="394" actId="1036"/>
          <ac:spMkLst>
            <pc:docMk/>
            <pc:sldMk cId="1393370754" sldId="256"/>
            <ac:spMk id="9" creationId="{5A38D8DF-4886-F41F-9508-079A964E18E8}"/>
          </ac:spMkLst>
        </pc:spChg>
        <pc:spChg chg="add mod">
          <ac:chgData name="Mohiuddin, Sayed Golam" userId="5c5f2d06-5da7-4463-8de7-92cf1264e307" providerId="ADAL" clId="{72DA5647-FC3B-4368-8059-A2DCD02654DF}" dt="2023-02-22T19:10:43.920" v="394" actId="1036"/>
          <ac:spMkLst>
            <pc:docMk/>
            <pc:sldMk cId="1393370754" sldId="256"/>
            <ac:spMk id="11" creationId="{A088BA6D-BD61-F58B-7145-66A3E752AF88}"/>
          </ac:spMkLst>
        </pc:spChg>
        <pc:spChg chg="add mod">
          <ac:chgData name="Mohiuddin, Sayed Golam" userId="5c5f2d06-5da7-4463-8de7-92cf1264e307" providerId="ADAL" clId="{72DA5647-FC3B-4368-8059-A2DCD02654DF}" dt="2023-02-22T19:10:43.920" v="394" actId="1036"/>
          <ac:spMkLst>
            <pc:docMk/>
            <pc:sldMk cId="1393370754" sldId="256"/>
            <ac:spMk id="12" creationId="{7BC91DAF-D055-672D-B7E8-01D0C56D8062}"/>
          </ac:spMkLst>
        </pc:spChg>
        <pc:spChg chg="add mod">
          <ac:chgData name="Mohiuddin, Sayed Golam" userId="5c5f2d06-5da7-4463-8de7-92cf1264e307" providerId="ADAL" clId="{72DA5647-FC3B-4368-8059-A2DCD02654DF}" dt="2023-02-22T19:10:43.920" v="394" actId="1036"/>
          <ac:spMkLst>
            <pc:docMk/>
            <pc:sldMk cId="1393370754" sldId="256"/>
            <ac:spMk id="13" creationId="{C0990A3B-F67B-EC3F-BE19-386EE2A92A49}"/>
          </ac:spMkLst>
        </pc:spChg>
        <pc:spChg chg="add mod">
          <ac:chgData name="Mohiuddin, Sayed Golam" userId="5c5f2d06-5da7-4463-8de7-92cf1264e307" providerId="ADAL" clId="{72DA5647-FC3B-4368-8059-A2DCD02654DF}" dt="2023-02-22T19:10:43.920" v="394" actId="1036"/>
          <ac:spMkLst>
            <pc:docMk/>
            <pc:sldMk cId="1393370754" sldId="256"/>
            <ac:spMk id="14" creationId="{43C289CB-7EE4-8156-B9DB-FBB4D6F4A75C}"/>
          </ac:spMkLst>
        </pc:spChg>
        <pc:spChg chg="add mod">
          <ac:chgData name="Mohiuddin, Sayed Golam" userId="5c5f2d06-5da7-4463-8de7-92cf1264e307" providerId="ADAL" clId="{72DA5647-FC3B-4368-8059-A2DCD02654DF}" dt="2023-02-22T19:10:43.920" v="394" actId="1036"/>
          <ac:spMkLst>
            <pc:docMk/>
            <pc:sldMk cId="1393370754" sldId="256"/>
            <ac:spMk id="15" creationId="{8A011965-3377-FB1F-F002-23F93DC52C0D}"/>
          </ac:spMkLst>
        </pc:spChg>
        <pc:spChg chg="add mod">
          <ac:chgData name="Mohiuddin, Sayed Golam" userId="5c5f2d06-5da7-4463-8de7-92cf1264e307" providerId="ADAL" clId="{72DA5647-FC3B-4368-8059-A2DCD02654DF}" dt="2023-02-22T19:10:43.920" v="394" actId="1036"/>
          <ac:spMkLst>
            <pc:docMk/>
            <pc:sldMk cId="1393370754" sldId="256"/>
            <ac:spMk id="17" creationId="{671B2DC2-2046-46EC-3ED2-EADFF581AC1B}"/>
          </ac:spMkLst>
        </pc:spChg>
        <pc:spChg chg="add mod">
          <ac:chgData name="Mohiuddin, Sayed Golam" userId="5c5f2d06-5da7-4463-8de7-92cf1264e307" providerId="ADAL" clId="{72DA5647-FC3B-4368-8059-A2DCD02654DF}" dt="2023-02-22T19:10:43.920" v="394" actId="1036"/>
          <ac:spMkLst>
            <pc:docMk/>
            <pc:sldMk cId="1393370754" sldId="256"/>
            <ac:spMk id="18" creationId="{54F79D6A-9543-7633-1A2F-FA8CC1FF2627}"/>
          </ac:spMkLst>
        </pc:spChg>
        <pc:spChg chg="add mod">
          <ac:chgData name="Mohiuddin, Sayed Golam" userId="5c5f2d06-5da7-4463-8de7-92cf1264e307" providerId="ADAL" clId="{72DA5647-FC3B-4368-8059-A2DCD02654DF}" dt="2023-02-22T19:10:43.920" v="394" actId="1036"/>
          <ac:spMkLst>
            <pc:docMk/>
            <pc:sldMk cId="1393370754" sldId="256"/>
            <ac:spMk id="19" creationId="{97BE781C-A6AA-D27A-94C0-B6B3DD05F4B0}"/>
          </ac:spMkLst>
        </pc:spChg>
        <pc:picChg chg="add mod">
          <ac:chgData name="Mohiuddin, Sayed Golam" userId="5c5f2d06-5da7-4463-8de7-92cf1264e307" providerId="ADAL" clId="{72DA5647-FC3B-4368-8059-A2DCD02654DF}" dt="2023-02-22T19:10:53.881" v="401" actId="1036"/>
          <ac:picMkLst>
            <pc:docMk/>
            <pc:sldMk cId="1393370754" sldId="256"/>
            <ac:picMk id="4" creationId="{AD16E06E-0BB9-304C-70FB-B5349DD5DB7A}"/>
          </ac:picMkLst>
        </pc:picChg>
        <pc:picChg chg="add mod">
          <ac:chgData name="Mohiuddin, Sayed Golam" userId="5c5f2d06-5da7-4463-8de7-92cf1264e307" providerId="ADAL" clId="{72DA5647-FC3B-4368-8059-A2DCD02654DF}" dt="2023-02-22T19:10:47.149" v="395" actId="1035"/>
          <ac:picMkLst>
            <pc:docMk/>
            <pc:sldMk cId="1393370754" sldId="256"/>
            <ac:picMk id="7" creationId="{E76DD2E3-070C-BA2D-DAA0-AF0F7E2DBB63}"/>
          </ac:picMkLst>
        </pc:picChg>
        <pc:picChg chg="add mod">
          <ac:chgData name="Mohiuddin, Sayed Golam" userId="5c5f2d06-5da7-4463-8de7-92cf1264e307" providerId="ADAL" clId="{72DA5647-FC3B-4368-8059-A2DCD02654DF}" dt="2023-02-22T19:10:43.920" v="394" actId="1036"/>
          <ac:picMkLst>
            <pc:docMk/>
            <pc:sldMk cId="1393370754" sldId="256"/>
            <ac:picMk id="10" creationId="{AE2F676E-9301-2879-17E5-DBF535E48A06}"/>
          </ac:picMkLst>
        </pc:picChg>
        <pc:picChg chg="add mod">
          <ac:chgData name="Mohiuddin, Sayed Golam" userId="5c5f2d06-5da7-4463-8de7-92cf1264e307" providerId="ADAL" clId="{72DA5647-FC3B-4368-8059-A2DCD02654DF}" dt="2023-02-22T19:10:43.920" v="394" actId="1036"/>
          <ac:picMkLst>
            <pc:docMk/>
            <pc:sldMk cId="1393370754" sldId="256"/>
            <ac:picMk id="16" creationId="{78424A46-F04A-DF78-5C3D-E727AA81880D}"/>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4E35BAE-08E0-4550-BE3E-1E676EA2E766}" type="datetimeFigureOut">
              <a:rPr lang="en-US" smtClean="0"/>
              <a:t>10/17/2024</a:t>
            </a:fld>
            <a:endParaRPr lang="en-US"/>
          </a:p>
        </p:txBody>
      </p:sp>
      <p:sp>
        <p:nvSpPr>
          <p:cNvPr id="4" name="Slide Image Placeholder 3"/>
          <p:cNvSpPr>
            <a:spLocks noGrp="1" noRot="1" noChangeAspect="1"/>
          </p:cNvSpPr>
          <p:nvPr>
            <p:ph type="sldImg" idx="2"/>
          </p:nvPr>
        </p:nvSpPr>
        <p:spPr>
          <a:xfrm>
            <a:off x="-758825" y="1143000"/>
            <a:ext cx="83756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6D0B41B-14C8-498A-8685-649AF97376B3}" type="slidenum">
              <a:rPr lang="en-US" smtClean="0"/>
              <a:t>‹#›</a:t>
            </a:fld>
            <a:endParaRPr lang="en-US"/>
          </a:p>
        </p:txBody>
      </p:sp>
    </p:spTree>
    <p:extLst>
      <p:ext uri="{BB962C8B-B14F-4D97-AF65-F5344CB8AC3E}">
        <p14:creationId xmlns:p14="http://schemas.microsoft.com/office/powerpoint/2010/main" val="11368057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58825" y="1143000"/>
            <a:ext cx="837565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6D0B41B-14C8-498A-8685-649AF97376B3}" type="slidenum">
              <a:rPr lang="en-US" smtClean="0"/>
              <a:t>1</a:t>
            </a:fld>
            <a:endParaRPr lang="en-US"/>
          </a:p>
        </p:txBody>
      </p:sp>
    </p:spTree>
    <p:extLst>
      <p:ext uri="{BB962C8B-B14F-4D97-AF65-F5344CB8AC3E}">
        <p14:creationId xmlns:p14="http://schemas.microsoft.com/office/powerpoint/2010/main" val="18375955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85850" y="523770"/>
            <a:ext cx="6515100" cy="1114213"/>
          </a:xfrm>
        </p:spPr>
        <p:txBody>
          <a:bodyPr anchor="b"/>
          <a:lstStyle>
            <a:lvl1pPr algn="ctr">
              <a:defRPr sz="2800"/>
            </a:lvl1pPr>
          </a:lstStyle>
          <a:p>
            <a:r>
              <a:rPr lang="en-US"/>
              <a:t>Click to edit Master title style</a:t>
            </a:r>
            <a:endParaRPr lang="en-US" dirty="0"/>
          </a:p>
        </p:txBody>
      </p:sp>
      <p:sp>
        <p:nvSpPr>
          <p:cNvPr id="3" name="Subtitle 2"/>
          <p:cNvSpPr>
            <a:spLocks noGrp="1"/>
          </p:cNvSpPr>
          <p:nvPr>
            <p:ph type="subTitle" idx="1"/>
          </p:nvPr>
        </p:nvSpPr>
        <p:spPr>
          <a:xfrm>
            <a:off x="1085850" y="1680951"/>
            <a:ext cx="6515100" cy="772689"/>
          </a:xfrm>
        </p:spPr>
        <p:txBody>
          <a:bodyPr/>
          <a:lstStyle>
            <a:lvl1pPr marL="0" indent="0" algn="ctr">
              <a:buNone/>
              <a:defRPr sz="1120"/>
            </a:lvl1pPr>
            <a:lvl2pPr marL="213375" indent="0" algn="ctr">
              <a:buNone/>
              <a:defRPr sz="933"/>
            </a:lvl2pPr>
            <a:lvl3pPr marL="426750" indent="0" algn="ctr">
              <a:buNone/>
              <a:defRPr sz="840"/>
            </a:lvl3pPr>
            <a:lvl4pPr marL="640126" indent="0" algn="ctr">
              <a:buNone/>
              <a:defRPr sz="747"/>
            </a:lvl4pPr>
            <a:lvl5pPr marL="853501" indent="0" algn="ctr">
              <a:buNone/>
              <a:defRPr sz="747"/>
            </a:lvl5pPr>
            <a:lvl6pPr marL="1066876" indent="0" algn="ctr">
              <a:buNone/>
              <a:defRPr sz="747"/>
            </a:lvl6pPr>
            <a:lvl7pPr marL="1280251" indent="0" algn="ctr">
              <a:buNone/>
              <a:defRPr sz="747"/>
            </a:lvl7pPr>
            <a:lvl8pPr marL="1493627" indent="0" algn="ctr">
              <a:buNone/>
              <a:defRPr sz="747"/>
            </a:lvl8pPr>
            <a:lvl9pPr marL="1707002" indent="0" algn="ctr">
              <a:buNone/>
              <a:defRPr sz="747"/>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1009317-E75A-4A99-A6B3-7F9D69B559C3}" type="datetimeFigureOut">
              <a:rPr lang="en-US" smtClean="0"/>
              <a:t>10/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19196060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009317-E75A-4A99-A6B3-7F9D69B559C3}" type="datetimeFigureOut">
              <a:rPr lang="en-US" smtClean="0"/>
              <a:t>10/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24630901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16491" y="170392"/>
            <a:ext cx="1873091" cy="271219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97217" y="170392"/>
            <a:ext cx="5510689" cy="271219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009317-E75A-4A99-A6B3-7F9D69B559C3}" type="datetimeFigureOut">
              <a:rPr lang="en-US" smtClean="0"/>
              <a:t>10/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32506489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009317-E75A-4A99-A6B3-7F9D69B559C3}" type="datetimeFigureOut">
              <a:rPr lang="en-US" smtClean="0"/>
              <a:t>10/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40651212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92693" y="797878"/>
            <a:ext cx="7492365" cy="1331277"/>
          </a:xfrm>
        </p:spPr>
        <p:txBody>
          <a:bodyPr anchor="b"/>
          <a:lstStyle>
            <a:lvl1pPr>
              <a:defRPr sz="2800"/>
            </a:lvl1pPr>
          </a:lstStyle>
          <a:p>
            <a:r>
              <a:rPr lang="en-US"/>
              <a:t>Click to edit Master title style</a:t>
            </a:r>
            <a:endParaRPr lang="en-US" dirty="0"/>
          </a:p>
        </p:txBody>
      </p:sp>
      <p:sp>
        <p:nvSpPr>
          <p:cNvPr id="3" name="Text Placeholder 2"/>
          <p:cNvSpPr>
            <a:spLocks noGrp="1"/>
          </p:cNvSpPr>
          <p:nvPr>
            <p:ph type="body" idx="1"/>
          </p:nvPr>
        </p:nvSpPr>
        <p:spPr>
          <a:xfrm>
            <a:off x="592693" y="2141750"/>
            <a:ext cx="7492365" cy="700087"/>
          </a:xfrm>
        </p:spPr>
        <p:txBody>
          <a:bodyPr/>
          <a:lstStyle>
            <a:lvl1pPr marL="0" indent="0">
              <a:buNone/>
              <a:defRPr sz="1120">
                <a:solidFill>
                  <a:schemeClr val="tx1">
                    <a:tint val="75000"/>
                  </a:schemeClr>
                </a:solidFill>
              </a:defRPr>
            </a:lvl1pPr>
            <a:lvl2pPr marL="213375" indent="0">
              <a:buNone/>
              <a:defRPr sz="933">
                <a:solidFill>
                  <a:schemeClr val="tx1">
                    <a:tint val="75000"/>
                  </a:schemeClr>
                </a:solidFill>
              </a:defRPr>
            </a:lvl2pPr>
            <a:lvl3pPr marL="426750" indent="0">
              <a:buNone/>
              <a:defRPr sz="840">
                <a:solidFill>
                  <a:schemeClr val="tx1">
                    <a:tint val="75000"/>
                  </a:schemeClr>
                </a:solidFill>
              </a:defRPr>
            </a:lvl3pPr>
            <a:lvl4pPr marL="640126" indent="0">
              <a:buNone/>
              <a:defRPr sz="747">
                <a:solidFill>
                  <a:schemeClr val="tx1">
                    <a:tint val="75000"/>
                  </a:schemeClr>
                </a:solidFill>
              </a:defRPr>
            </a:lvl4pPr>
            <a:lvl5pPr marL="853501" indent="0">
              <a:buNone/>
              <a:defRPr sz="747">
                <a:solidFill>
                  <a:schemeClr val="tx1">
                    <a:tint val="75000"/>
                  </a:schemeClr>
                </a:solidFill>
              </a:defRPr>
            </a:lvl5pPr>
            <a:lvl6pPr marL="1066876" indent="0">
              <a:buNone/>
              <a:defRPr sz="747">
                <a:solidFill>
                  <a:schemeClr val="tx1">
                    <a:tint val="75000"/>
                  </a:schemeClr>
                </a:solidFill>
              </a:defRPr>
            </a:lvl6pPr>
            <a:lvl7pPr marL="1280251" indent="0">
              <a:buNone/>
              <a:defRPr sz="747">
                <a:solidFill>
                  <a:schemeClr val="tx1">
                    <a:tint val="75000"/>
                  </a:schemeClr>
                </a:solidFill>
              </a:defRPr>
            </a:lvl7pPr>
            <a:lvl8pPr marL="1493627" indent="0">
              <a:buNone/>
              <a:defRPr sz="747">
                <a:solidFill>
                  <a:schemeClr val="tx1">
                    <a:tint val="75000"/>
                  </a:schemeClr>
                </a:solidFill>
              </a:defRPr>
            </a:lvl8pPr>
            <a:lvl9pPr marL="1707002" indent="0">
              <a:buNone/>
              <a:defRPr sz="747">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1009317-E75A-4A99-A6B3-7F9D69B559C3}" type="datetimeFigureOut">
              <a:rPr lang="en-US" smtClean="0"/>
              <a:t>10/1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19821123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97218" y="851959"/>
            <a:ext cx="3691890" cy="203062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397693" y="851959"/>
            <a:ext cx="3691890" cy="203062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1009317-E75A-4A99-A6B3-7F9D69B559C3}" type="datetimeFigureOut">
              <a:rPr lang="en-US" smtClean="0"/>
              <a:t>10/1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21277559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8349" y="170392"/>
            <a:ext cx="7492365" cy="618596"/>
          </a:xfrm>
        </p:spPr>
        <p:txBody>
          <a:bodyPr/>
          <a:lstStyle/>
          <a:p>
            <a:r>
              <a:rPr lang="en-US"/>
              <a:t>Click to edit Master title style</a:t>
            </a:r>
            <a:endParaRPr lang="en-US" dirty="0"/>
          </a:p>
        </p:txBody>
      </p:sp>
      <p:sp>
        <p:nvSpPr>
          <p:cNvPr id="3" name="Text Placeholder 2"/>
          <p:cNvSpPr>
            <a:spLocks noGrp="1"/>
          </p:cNvSpPr>
          <p:nvPr>
            <p:ph type="body" idx="1"/>
          </p:nvPr>
        </p:nvSpPr>
        <p:spPr>
          <a:xfrm>
            <a:off x="598349" y="784543"/>
            <a:ext cx="3674923" cy="384492"/>
          </a:xfrm>
        </p:spPr>
        <p:txBody>
          <a:bodyPr anchor="b"/>
          <a:lstStyle>
            <a:lvl1pPr marL="0" indent="0">
              <a:buNone/>
              <a:defRPr sz="1120" b="1"/>
            </a:lvl1pPr>
            <a:lvl2pPr marL="213375" indent="0">
              <a:buNone/>
              <a:defRPr sz="933" b="1"/>
            </a:lvl2pPr>
            <a:lvl3pPr marL="426750" indent="0">
              <a:buNone/>
              <a:defRPr sz="840" b="1"/>
            </a:lvl3pPr>
            <a:lvl4pPr marL="640126" indent="0">
              <a:buNone/>
              <a:defRPr sz="747" b="1"/>
            </a:lvl4pPr>
            <a:lvl5pPr marL="853501" indent="0">
              <a:buNone/>
              <a:defRPr sz="747" b="1"/>
            </a:lvl5pPr>
            <a:lvl6pPr marL="1066876" indent="0">
              <a:buNone/>
              <a:defRPr sz="747" b="1"/>
            </a:lvl6pPr>
            <a:lvl7pPr marL="1280251" indent="0">
              <a:buNone/>
              <a:defRPr sz="747" b="1"/>
            </a:lvl7pPr>
            <a:lvl8pPr marL="1493627" indent="0">
              <a:buNone/>
              <a:defRPr sz="747" b="1"/>
            </a:lvl8pPr>
            <a:lvl9pPr marL="1707002" indent="0">
              <a:buNone/>
              <a:defRPr sz="747" b="1"/>
            </a:lvl9pPr>
          </a:lstStyle>
          <a:p>
            <a:pPr lvl="0"/>
            <a:r>
              <a:rPr lang="en-US"/>
              <a:t>Click to edit Master text styles</a:t>
            </a:r>
          </a:p>
        </p:txBody>
      </p:sp>
      <p:sp>
        <p:nvSpPr>
          <p:cNvPr id="4" name="Content Placeholder 3"/>
          <p:cNvSpPr>
            <a:spLocks noGrp="1"/>
          </p:cNvSpPr>
          <p:nvPr>
            <p:ph sz="half" idx="2"/>
          </p:nvPr>
        </p:nvSpPr>
        <p:spPr>
          <a:xfrm>
            <a:off x="598349" y="1169035"/>
            <a:ext cx="3674923" cy="17194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397693" y="784543"/>
            <a:ext cx="3693021" cy="384492"/>
          </a:xfrm>
        </p:spPr>
        <p:txBody>
          <a:bodyPr anchor="b"/>
          <a:lstStyle>
            <a:lvl1pPr marL="0" indent="0">
              <a:buNone/>
              <a:defRPr sz="1120" b="1"/>
            </a:lvl1pPr>
            <a:lvl2pPr marL="213375" indent="0">
              <a:buNone/>
              <a:defRPr sz="933" b="1"/>
            </a:lvl2pPr>
            <a:lvl3pPr marL="426750" indent="0">
              <a:buNone/>
              <a:defRPr sz="840" b="1"/>
            </a:lvl3pPr>
            <a:lvl4pPr marL="640126" indent="0">
              <a:buNone/>
              <a:defRPr sz="747" b="1"/>
            </a:lvl4pPr>
            <a:lvl5pPr marL="853501" indent="0">
              <a:buNone/>
              <a:defRPr sz="747" b="1"/>
            </a:lvl5pPr>
            <a:lvl6pPr marL="1066876" indent="0">
              <a:buNone/>
              <a:defRPr sz="747" b="1"/>
            </a:lvl6pPr>
            <a:lvl7pPr marL="1280251" indent="0">
              <a:buNone/>
              <a:defRPr sz="747" b="1"/>
            </a:lvl7pPr>
            <a:lvl8pPr marL="1493627" indent="0">
              <a:buNone/>
              <a:defRPr sz="747" b="1"/>
            </a:lvl8pPr>
            <a:lvl9pPr marL="1707002" indent="0">
              <a:buNone/>
              <a:defRPr sz="747" b="1"/>
            </a:lvl9pPr>
          </a:lstStyle>
          <a:p>
            <a:pPr lvl="0"/>
            <a:r>
              <a:rPr lang="en-US"/>
              <a:t>Click to edit Master text styles</a:t>
            </a:r>
          </a:p>
        </p:txBody>
      </p:sp>
      <p:sp>
        <p:nvSpPr>
          <p:cNvPr id="6" name="Content Placeholder 5"/>
          <p:cNvSpPr>
            <a:spLocks noGrp="1"/>
          </p:cNvSpPr>
          <p:nvPr>
            <p:ph sz="quarter" idx="4"/>
          </p:nvPr>
        </p:nvSpPr>
        <p:spPr>
          <a:xfrm>
            <a:off x="4397693" y="1169035"/>
            <a:ext cx="3693021" cy="171947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1009317-E75A-4A99-A6B3-7F9D69B559C3}" type="datetimeFigureOut">
              <a:rPr lang="en-US" smtClean="0"/>
              <a:t>10/1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22077104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1009317-E75A-4A99-A6B3-7F9D69B559C3}" type="datetimeFigureOut">
              <a:rPr lang="en-US" smtClean="0"/>
              <a:t>10/1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22078670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009317-E75A-4A99-A6B3-7F9D69B559C3}" type="datetimeFigureOut">
              <a:rPr lang="en-US" smtClean="0"/>
              <a:t>10/1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20509709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8349" y="213360"/>
            <a:ext cx="2801719" cy="746760"/>
          </a:xfrm>
        </p:spPr>
        <p:txBody>
          <a:bodyPr anchor="b"/>
          <a:lstStyle>
            <a:lvl1pPr>
              <a:defRPr sz="1493"/>
            </a:lvl1pPr>
          </a:lstStyle>
          <a:p>
            <a:r>
              <a:rPr lang="en-US"/>
              <a:t>Click to edit Master title style</a:t>
            </a:r>
            <a:endParaRPr lang="en-US" dirty="0"/>
          </a:p>
        </p:txBody>
      </p:sp>
      <p:sp>
        <p:nvSpPr>
          <p:cNvPr id="3" name="Content Placeholder 2"/>
          <p:cNvSpPr>
            <a:spLocks noGrp="1"/>
          </p:cNvSpPr>
          <p:nvPr>
            <p:ph idx="1"/>
          </p:nvPr>
        </p:nvSpPr>
        <p:spPr>
          <a:xfrm>
            <a:off x="3693021" y="460799"/>
            <a:ext cx="4397693" cy="2274358"/>
          </a:xfrm>
        </p:spPr>
        <p:txBody>
          <a:bodyPr/>
          <a:lstStyle>
            <a:lvl1pPr>
              <a:defRPr sz="1493"/>
            </a:lvl1pPr>
            <a:lvl2pPr>
              <a:defRPr sz="1307"/>
            </a:lvl2pPr>
            <a:lvl3pPr>
              <a:defRPr sz="1120"/>
            </a:lvl3pPr>
            <a:lvl4pPr>
              <a:defRPr sz="933"/>
            </a:lvl4pPr>
            <a:lvl5pPr>
              <a:defRPr sz="933"/>
            </a:lvl5pPr>
            <a:lvl6pPr>
              <a:defRPr sz="933"/>
            </a:lvl6pPr>
            <a:lvl7pPr>
              <a:defRPr sz="933"/>
            </a:lvl7pPr>
            <a:lvl8pPr>
              <a:defRPr sz="933"/>
            </a:lvl8pPr>
            <a:lvl9pPr>
              <a:defRPr sz="933"/>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98349" y="960120"/>
            <a:ext cx="2801719" cy="1778741"/>
          </a:xfrm>
        </p:spPr>
        <p:txBody>
          <a:bodyPr/>
          <a:lstStyle>
            <a:lvl1pPr marL="0" indent="0">
              <a:buNone/>
              <a:defRPr sz="747"/>
            </a:lvl1pPr>
            <a:lvl2pPr marL="213375" indent="0">
              <a:buNone/>
              <a:defRPr sz="653"/>
            </a:lvl2pPr>
            <a:lvl3pPr marL="426750" indent="0">
              <a:buNone/>
              <a:defRPr sz="560"/>
            </a:lvl3pPr>
            <a:lvl4pPr marL="640126" indent="0">
              <a:buNone/>
              <a:defRPr sz="467"/>
            </a:lvl4pPr>
            <a:lvl5pPr marL="853501" indent="0">
              <a:buNone/>
              <a:defRPr sz="467"/>
            </a:lvl5pPr>
            <a:lvl6pPr marL="1066876" indent="0">
              <a:buNone/>
              <a:defRPr sz="467"/>
            </a:lvl6pPr>
            <a:lvl7pPr marL="1280251" indent="0">
              <a:buNone/>
              <a:defRPr sz="467"/>
            </a:lvl7pPr>
            <a:lvl8pPr marL="1493627" indent="0">
              <a:buNone/>
              <a:defRPr sz="467"/>
            </a:lvl8pPr>
            <a:lvl9pPr marL="1707002" indent="0">
              <a:buNone/>
              <a:defRPr sz="467"/>
            </a:lvl9pPr>
          </a:lstStyle>
          <a:p>
            <a:pPr lvl="0"/>
            <a:r>
              <a:rPr lang="en-US"/>
              <a:t>Click to edit Master text styles</a:t>
            </a:r>
          </a:p>
        </p:txBody>
      </p:sp>
      <p:sp>
        <p:nvSpPr>
          <p:cNvPr id="5" name="Date Placeholder 4"/>
          <p:cNvSpPr>
            <a:spLocks noGrp="1"/>
          </p:cNvSpPr>
          <p:nvPr>
            <p:ph type="dt" sz="half" idx="10"/>
          </p:nvPr>
        </p:nvSpPr>
        <p:spPr/>
        <p:txBody>
          <a:bodyPr/>
          <a:lstStyle/>
          <a:p>
            <a:fld id="{51009317-E75A-4A99-A6B3-7F9D69B559C3}" type="datetimeFigureOut">
              <a:rPr lang="en-US" smtClean="0"/>
              <a:t>10/1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7579165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8349" y="213360"/>
            <a:ext cx="2801719" cy="746760"/>
          </a:xfrm>
        </p:spPr>
        <p:txBody>
          <a:bodyPr anchor="b"/>
          <a:lstStyle>
            <a:lvl1pPr>
              <a:defRPr sz="1493"/>
            </a:lvl1pPr>
          </a:lstStyle>
          <a:p>
            <a:r>
              <a:rPr lang="en-US"/>
              <a:t>Click to edit Master title style</a:t>
            </a:r>
            <a:endParaRPr lang="en-US" dirty="0"/>
          </a:p>
        </p:txBody>
      </p:sp>
      <p:sp>
        <p:nvSpPr>
          <p:cNvPr id="3" name="Picture Placeholder 2"/>
          <p:cNvSpPr>
            <a:spLocks noGrp="1" noChangeAspect="1"/>
          </p:cNvSpPr>
          <p:nvPr>
            <p:ph type="pic" idx="1"/>
          </p:nvPr>
        </p:nvSpPr>
        <p:spPr>
          <a:xfrm>
            <a:off x="3693021" y="460799"/>
            <a:ext cx="4397693" cy="2274358"/>
          </a:xfrm>
        </p:spPr>
        <p:txBody>
          <a:bodyPr anchor="t"/>
          <a:lstStyle>
            <a:lvl1pPr marL="0" indent="0">
              <a:buNone/>
              <a:defRPr sz="1493"/>
            </a:lvl1pPr>
            <a:lvl2pPr marL="213375" indent="0">
              <a:buNone/>
              <a:defRPr sz="1307"/>
            </a:lvl2pPr>
            <a:lvl3pPr marL="426750" indent="0">
              <a:buNone/>
              <a:defRPr sz="1120"/>
            </a:lvl3pPr>
            <a:lvl4pPr marL="640126" indent="0">
              <a:buNone/>
              <a:defRPr sz="933"/>
            </a:lvl4pPr>
            <a:lvl5pPr marL="853501" indent="0">
              <a:buNone/>
              <a:defRPr sz="933"/>
            </a:lvl5pPr>
            <a:lvl6pPr marL="1066876" indent="0">
              <a:buNone/>
              <a:defRPr sz="933"/>
            </a:lvl6pPr>
            <a:lvl7pPr marL="1280251" indent="0">
              <a:buNone/>
              <a:defRPr sz="933"/>
            </a:lvl7pPr>
            <a:lvl8pPr marL="1493627" indent="0">
              <a:buNone/>
              <a:defRPr sz="933"/>
            </a:lvl8pPr>
            <a:lvl9pPr marL="1707002" indent="0">
              <a:buNone/>
              <a:defRPr sz="933"/>
            </a:lvl9pPr>
          </a:lstStyle>
          <a:p>
            <a:r>
              <a:rPr lang="en-US"/>
              <a:t>Click icon to add picture</a:t>
            </a:r>
            <a:endParaRPr lang="en-US" dirty="0"/>
          </a:p>
        </p:txBody>
      </p:sp>
      <p:sp>
        <p:nvSpPr>
          <p:cNvPr id="4" name="Text Placeholder 3"/>
          <p:cNvSpPr>
            <a:spLocks noGrp="1"/>
          </p:cNvSpPr>
          <p:nvPr>
            <p:ph type="body" sz="half" idx="2"/>
          </p:nvPr>
        </p:nvSpPr>
        <p:spPr>
          <a:xfrm>
            <a:off x="598349" y="960120"/>
            <a:ext cx="2801719" cy="1778741"/>
          </a:xfrm>
        </p:spPr>
        <p:txBody>
          <a:bodyPr/>
          <a:lstStyle>
            <a:lvl1pPr marL="0" indent="0">
              <a:buNone/>
              <a:defRPr sz="747"/>
            </a:lvl1pPr>
            <a:lvl2pPr marL="213375" indent="0">
              <a:buNone/>
              <a:defRPr sz="653"/>
            </a:lvl2pPr>
            <a:lvl3pPr marL="426750" indent="0">
              <a:buNone/>
              <a:defRPr sz="560"/>
            </a:lvl3pPr>
            <a:lvl4pPr marL="640126" indent="0">
              <a:buNone/>
              <a:defRPr sz="467"/>
            </a:lvl4pPr>
            <a:lvl5pPr marL="853501" indent="0">
              <a:buNone/>
              <a:defRPr sz="467"/>
            </a:lvl5pPr>
            <a:lvl6pPr marL="1066876" indent="0">
              <a:buNone/>
              <a:defRPr sz="467"/>
            </a:lvl6pPr>
            <a:lvl7pPr marL="1280251" indent="0">
              <a:buNone/>
              <a:defRPr sz="467"/>
            </a:lvl7pPr>
            <a:lvl8pPr marL="1493627" indent="0">
              <a:buNone/>
              <a:defRPr sz="467"/>
            </a:lvl8pPr>
            <a:lvl9pPr marL="1707002" indent="0">
              <a:buNone/>
              <a:defRPr sz="467"/>
            </a:lvl9pPr>
          </a:lstStyle>
          <a:p>
            <a:pPr lvl="0"/>
            <a:r>
              <a:rPr lang="en-US"/>
              <a:t>Click to edit Master text styles</a:t>
            </a:r>
          </a:p>
        </p:txBody>
      </p:sp>
      <p:sp>
        <p:nvSpPr>
          <p:cNvPr id="5" name="Date Placeholder 4"/>
          <p:cNvSpPr>
            <a:spLocks noGrp="1"/>
          </p:cNvSpPr>
          <p:nvPr>
            <p:ph type="dt" sz="half" idx="10"/>
          </p:nvPr>
        </p:nvSpPr>
        <p:spPr/>
        <p:txBody>
          <a:bodyPr/>
          <a:lstStyle/>
          <a:p>
            <a:fld id="{51009317-E75A-4A99-A6B3-7F9D69B559C3}" type="datetimeFigureOut">
              <a:rPr lang="en-US" smtClean="0"/>
              <a:t>10/1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BE584AD-77C7-44C3-B7ED-C870916427F0}" type="slidenum">
              <a:rPr lang="en-US" smtClean="0"/>
              <a:t>‹#›</a:t>
            </a:fld>
            <a:endParaRPr lang="en-US"/>
          </a:p>
        </p:txBody>
      </p:sp>
    </p:spTree>
    <p:extLst>
      <p:ext uri="{BB962C8B-B14F-4D97-AF65-F5344CB8AC3E}">
        <p14:creationId xmlns:p14="http://schemas.microsoft.com/office/powerpoint/2010/main" val="29507167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97218" y="170392"/>
            <a:ext cx="7492365" cy="61859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97218" y="851959"/>
            <a:ext cx="7492365" cy="203062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97218" y="2966297"/>
            <a:ext cx="1954530" cy="170392"/>
          </a:xfrm>
          <a:prstGeom prst="rect">
            <a:avLst/>
          </a:prstGeom>
        </p:spPr>
        <p:txBody>
          <a:bodyPr vert="horz" lIns="91440" tIns="45720" rIns="91440" bIns="45720" rtlCol="0" anchor="ctr"/>
          <a:lstStyle>
            <a:lvl1pPr algn="l">
              <a:defRPr sz="560">
                <a:solidFill>
                  <a:schemeClr val="tx1">
                    <a:tint val="75000"/>
                  </a:schemeClr>
                </a:solidFill>
              </a:defRPr>
            </a:lvl1pPr>
          </a:lstStyle>
          <a:p>
            <a:fld id="{51009317-E75A-4A99-A6B3-7F9D69B559C3}" type="datetimeFigureOut">
              <a:rPr lang="en-US" smtClean="0"/>
              <a:t>10/17/2024</a:t>
            </a:fld>
            <a:endParaRPr lang="en-US"/>
          </a:p>
        </p:txBody>
      </p:sp>
      <p:sp>
        <p:nvSpPr>
          <p:cNvPr id="5" name="Footer Placeholder 4"/>
          <p:cNvSpPr>
            <a:spLocks noGrp="1"/>
          </p:cNvSpPr>
          <p:nvPr>
            <p:ph type="ftr" sz="quarter" idx="3"/>
          </p:nvPr>
        </p:nvSpPr>
        <p:spPr>
          <a:xfrm>
            <a:off x="2877503" y="2966297"/>
            <a:ext cx="2931795" cy="170392"/>
          </a:xfrm>
          <a:prstGeom prst="rect">
            <a:avLst/>
          </a:prstGeom>
        </p:spPr>
        <p:txBody>
          <a:bodyPr vert="horz" lIns="91440" tIns="45720" rIns="91440" bIns="45720" rtlCol="0" anchor="ctr"/>
          <a:lstStyle>
            <a:lvl1pPr algn="ctr">
              <a:defRPr sz="5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135053" y="2966297"/>
            <a:ext cx="1954530" cy="170392"/>
          </a:xfrm>
          <a:prstGeom prst="rect">
            <a:avLst/>
          </a:prstGeom>
        </p:spPr>
        <p:txBody>
          <a:bodyPr vert="horz" lIns="91440" tIns="45720" rIns="91440" bIns="45720" rtlCol="0" anchor="ctr"/>
          <a:lstStyle>
            <a:lvl1pPr algn="r">
              <a:defRPr sz="560">
                <a:solidFill>
                  <a:schemeClr val="tx1">
                    <a:tint val="75000"/>
                  </a:schemeClr>
                </a:solidFill>
              </a:defRPr>
            </a:lvl1pPr>
          </a:lstStyle>
          <a:p>
            <a:fld id="{9BE584AD-77C7-44C3-B7ED-C870916427F0}" type="slidenum">
              <a:rPr lang="en-US" smtClean="0"/>
              <a:t>‹#›</a:t>
            </a:fld>
            <a:endParaRPr lang="en-US"/>
          </a:p>
        </p:txBody>
      </p:sp>
    </p:spTree>
    <p:extLst>
      <p:ext uri="{BB962C8B-B14F-4D97-AF65-F5344CB8AC3E}">
        <p14:creationId xmlns:p14="http://schemas.microsoft.com/office/powerpoint/2010/main" val="2606925396"/>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426750" rtl="0" eaLnBrk="1" latinLnBrk="0" hangingPunct="1">
        <a:lnSpc>
          <a:spcPct val="90000"/>
        </a:lnSpc>
        <a:spcBef>
          <a:spcPct val="0"/>
        </a:spcBef>
        <a:buNone/>
        <a:defRPr sz="2053" kern="1200">
          <a:solidFill>
            <a:schemeClr val="tx1"/>
          </a:solidFill>
          <a:latin typeface="+mj-lt"/>
          <a:ea typeface="+mj-ea"/>
          <a:cs typeface="+mj-cs"/>
        </a:defRPr>
      </a:lvl1pPr>
    </p:titleStyle>
    <p:bodyStyle>
      <a:lvl1pPr marL="106688" indent="-106688" algn="l" defTabSz="426750" rtl="0" eaLnBrk="1" latinLnBrk="0" hangingPunct="1">
        <a:lnSpc>
          <a:spcPct val="90000"/>
        </a:lnSpc>
        <a:spcBef>
          <a:spcPts val="467"/>
        </a:spcBef>
        <a:buFont typeface="Arial" panose="020B0604020202020204" pitchFamily="34" charset="0"/>
        <a:buChar char="•"/>
        <a:defRPr sz="1307" kern="1200">
          <a:solidFill>
            <a:schemeClr val="tx1"/>
          </a:solidFill>
          <a:latin typeface="+mn-lt"/>
          <a:ea typeface="+mn-ea"/>
          <a:cs typeface="+mn-cs"/>
        </a:defRPr>
      </a:lvl1pPr>
      <a:lvl2pPr marL="320063" indent="-106688" algn="l" defTabSz="426750" rtl="0" eaLnBrk="1" latinLnBrk="0" hangingPunct="1">
        <a:lnSpc>
          <a:spcPct val="90000"/>
        </a:lnSpc>
        <a:spcBef>
          <a:spcPts val="233"/>
        </a:spcBef>
        <a:buFont typeface="Arial" panose="020B0604020202020204" pitchFamily="34" charset="0"/>
        <a:buChar char="•"/>
        <a:defRPr sz="1120" kern="1200">
          <a:solidFill>
            <a:schemeClr val="tx1"/>
          </a:solidFill>
          <a:latin typeface="+mn-lt"/>
          <a:ea typeface="+mn-ea"/>
          <a:cs typeface="+mn-cs"/>
        </a:defRPr>
      </a:lvl2pPr>
      <a:lvl3pPr marL="533438" indent="-106688" algn="l" defTabSz="426750" rtl="0" eaLnBrk="1" latinLnBrk="0" hangingPunct="1">
        <a:lnSpc>
          <a:spcPct val="90000"/>
        </a:lnSpc>
        <a:spcBef>
          <a:spcPts val="233"/>
        </a:spcBef>
        <a:buFont typeface="Arial" panose="020B0604020202020204" pitchFamily="34" charset="0"/>
        <a:buChar char="•"/>
        <a:defRPr sz="933" kern="1200">
          <a:solidFill>
            <a:schemeClr val="tx1"/>
          </a:solidFill>
          <a:latin typeface="+mn-lt"/>
          <a:ea typeface="+mn-ea"/>
          <a:cs typeface="+mn-cs"/>
        </a:defRPr>
      </a:lvl3pPr>
      <a:lvl4pPr marL="746813" indent="-106688" algn="l" defTabSz="426750" rtl="0" eaLnBrk="1" latinLnBrk="0" hangingPunct="1">
        <a:lnSpc>
          <a:spcPct val="90000"/>
        </a:lnSpc>
        <a:spcBef>
          <a:spcPts val="233"/>
        </a:spcBef>
        <a:buFont typeface="Arial" panose="020B0604020202020204" pitchFamily="34" charset="0"/>
        <a:buChar char="•"/>
        <a:defRPr sz="840" kern="1200">
          <a:solidFill>
            <a:schemeClr val="tx1"/>
          </a:solidFill>
          <a:latin typeface="+mn-lt"/>
          <a:ea typeface="+mn-ea"/>
          <a:cs typeface="+mn-cs"/>
        </a:defRPr>
      </a:lvl4pPr>
      <a:lvl5pPr marL="960189" indent="-106688" algn="l" defTabSz="426750" rtl="0" eaLnBrk="1" latinLnBrk="0" hangingPunct="1">
        <a:lnSpc>
          <a:spcPct val="90000"/>
        </a:lnSpc>
        <a:spcBef>
          <a:spcPts val="233"/>
        </a:spcBef>
        <a:buFont typeface="Arial" panose="020B0604020202020204" pitchFamily="34" charset="0"/>
        <a:buChar char="•"/>
        <a:defRPr sz="840" kern="1200">
          <a:solidFill>
            <a:schemeClr val="tx1"/>
          </a:solidFill>
          <a:latin typeface="+mn-lt"/>
          <a:ea typeface="+mn-ea"/>
          <a:cs typeface="+mn-cs"/>
        </a:defRPr>
      </a:lvl5pPr>
      <a:lvl6pPr marL="1173564" indent="-106688" algn="l" defTabSz="426750" rtl="0" eaLnBrk="1" latinLnBrk="0" hangingPunct="1">
        <a:lnSpc>
          <a:spcPct val="90000"/>
        </a:lnSpc>
        <a:spcBef>
          <a:spcPts val="233"/>
        </a:spcBef>
        <a:buFont typeface="Arial" panose="020B0604020202020204" pitchFamily="34" charset="0"/>
        <a:buChar char="•"/>
        <a:defRPr sz="840" kern="1200">
          <a:solidFill>
            <a:schemeClr val="tx1"/>
          </a:solidFill>
          <a:latin typeface="+mn-lt"/>
          <a:ea typeface="+mn-ea"/>
          <a:cs typeface="+mn-cs"/>
        </a:defRPr>
      </a:lvl6pPr>
      <a:lvl7pPr marL="1386939" indent="-106688" algn="l" defTabSz="426750" rtl="0" eaLnBrk="1" latinLnBrk="0" hangingPunct="1">
        <a:lnSpc>
          <a:spcPct val="90000"/>
        </a:lnSpc>
        <a:spcBef>
          <a:spcPts val="233"/>
        </a:spcBef>
        <a:buFont typeface="Arial" panose="020B0604020202020204" pitchFamily="34" charset="0"/>
        <a:buChar char="•"/>
        <a:defRPr sz="840" kern="1200">
          <a:solidFill>
            <a:schemeClr val="tx1"/>
          </a:solidFill>
          <a:latin typeface="+mn-lt"/>
          <a:ea typeface="+mn-ea"/>
          <a:cs typeface="+mn-cs"/>
        </a:defRPr>
      </a:lvl7pPr>
      <a:lvl8pPr marL="1600314" indent="-106688" algn="l" defTabSz="426750" rtl="0" eaLnBrk="1" latinLnBrk="0" hangingPunct="1">
        <a:lnSpc>
          <a:spcPct val="90000"/>
        </a:lnSpc>
        <a:spcBef>
          <a:spcPts val="233"/>
        </a:spcBef>
        <a:buFont typeface="Arial" panose="020B0604020202020204" pitchFamily="34" charset="0"/>
        <a:buChar char="•"/>
        <a:defRPr sz="840" kern="1200">
          <a:solidFill>
            <a:schemeClr val="tx1"/>
          </a:solidFill>
          <a:latin typeface="+mn-lt"/>
          <a:ea typeface="+mn-ea"/>
          <a:cs typeface="+mn-cs"/>
        </a:defRPr>
      </a:lvl8pPr>
      <a:lvl9pPr marL="1813690" indent="-106688" algn="l" defTabSz="426750" rtl="0" eaLnBrk="1" latinLnBrk="0" hangingPunct="1">
        <a:lnSpc>
          <a:spcPct val="90000"/>
        </a:lnSpc>
        <a:spcBef>
          <a:spcPts val="233"/>
        </a:spcBef>
        <a:buFont typeface="Arial" panose="020B0604020202020204" pitchFamily="34" charset="0"/>
        <a:buChar char="•"/>
        <a:defRPr sz="840" kern="1200">
          <a:solidFill>
            <a:schemeClr val="tx1"/>
          </a:solidFill>
          <a:latin typeface="+mn-lt"/>
          <a:ea typeface="+mn-ea"/>
          <a:cs typeface="+mn-cs"/>
        </a:defRPr>
      </a:lvl9pPr>
    </p:bodyStyle>
    <p:otherStyle>
      <a:defPPr>
        <a:defRPr lang="en-US"/>
      </a:defPPr>
      <a:lvl1pPr marL="0" algn="l" defTabSz="426750" rtl="0" eaLnBrk="1" latinLnBrk="0" hangingPunct="1">
        <a:defRPr sz="840" kern="1200">
          <a:solidFill>
            <a:schemeClr val="tx1"/>
          </a:solidFill>
          <a:latin typeface="+mn-lt"/>
          <a:ea typeface="+mn-ea"/>
          <a:cs typeface="+mn-cs"/>
        </a:defRPr>
      </a:lvl1pPr>
      <a:lvl2pPr marL="213375" algn="l" defTabSz="426750" rtl="0" eaLnBrk="1" latinLnBrk="0" hangingPunct="1">
        <a:defRPr sz="840" kern="1200">
          <a:solidFill>
            <a:schemeClr val="tx1"/>
          </a:solidFill>
          <a:latin typeface="+mn-lt"/>
          <a:ea typeface="+mn-ea"/>
          <a:cs typeface="+mn-cs"/>
        </a:defRPr>
      </a:lvl2pPr>
      <a:lvl3pPr marL="426750" algn="l" defTabSz="426750" rtl="0" eaLnBrk="1" latinLnBrk="0" hangingPunct="1">
        <a:defRPr sz="840" kern="1200">
          <a:solidFill>
            <a:schemeClr val="tx1"/>
          </a:solidFill>
          <a:latin typeface="+mn-lt"/>
          <a:ea typeface="+mn-ea"/>
          <a:cs typeface="+mn-cs"/>
        </a:defRPr>
      </a:lvl3pPr>
      <a:lvl4pPr marL="640126" algn="l" defTabSz="426750" rtl="0" eaLnBrk="1" latinLnBrk="0" hangingPunct="1">
        <a:defRPr sz="840" kern="1200">
          <a:solidFill>
            <a:schemeClr val="tx1"/>
          </a:solidFill>
          <a:latin typeface="+mn-lt"/>
          <a:ea typeface="+mn-ea"/>
          <a:cs typeface="+mn-cs"/>
        </a:defRPr>
      </a:lvl4pPr>
      <a:lvl5pPr marL="853501" algn="l" defTabSz="426750" rtl="0" eaLnBrk="1" latinLnBrk="0" hangingPunct="1">
        <a:defRPr sz="840" kern="1200">
          <a:solidFill>
            <a:schemeClr val="tx1"/>
          </a:solidFill>
          <a:latin typeface="+mn-lt"/>
          <a:ea typeface="+mn-ea"/>
          <a:cs typeface="+mn-cs"/>
        </a:defRPr>
      </a:lvl5pPr>
      <a:lvl6pPr marL="1066876" algn="l" defTabSz="426750" rtl="0" eaLnBrk="1" latinLnBrk="0" hangingPunct="1">
        <a:defRPr sz="840" kern="1200">
          <a:solidFill>
            <a:schemeClr val="tx1"/>
          </a:solidFill>
          <a:latin typeface="+mn-lt"/>
          <a:ea typeface="+mn-ea"/>
          <a:cs typeface="+mn-cs"/>
        </a:defRPr>
      </a:lvl6pPr>
      <a:lvl7pPr marL="1280251" algn="l" defTabSz="426750" rtl="0" eaLnBrk="1" latinLnBrk="0" hangingPunct="1">
        <a:defRPr sz="840" kern="1200">
          <a:solidFill>
            <a:schemeClr val="tx1"/>
          </a:solidFill>
          <a:latin typeface="+mn-lt"/>
          <a:ea typeface="+mn-ea"/>
          <a:cs typeface="+mn-cs"/>
        </a:defRPr>
      </a:lvl7pPr>
      <a:lvl8pPr marL="1493627" algn="l" defTabSz="426750" rtl="0" eaLnBrk="1" latinLnBrk="0" hangingPunct="1">
        <a:defRPr sz="840" kern="1200">
          <a:solidFill>
            <a:schemeClr val="tx1"/>
          </a:solidFill>
          <a:latin typeface="+mn-lt"/>
          <a:ea typeface="+mn-ea"/>
          <a:cs typeface="+mn-cs"/>
        </a:defRPr>
      </a:lvl8pPr>
      <a:lvl9pPr marL="1707002" algn="l" defTabSz="426750" rtl="0" eaLnBrk="1" latinLnBrk="0" hangingPunct="1">
        <a:defRPr sz="8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video" Target="../media/media4.mp4"/><Relationship Id="rId13" Type="http://schemas.openxmlformats.org/officeDocument/2006/relationships/image" Target="../media/image3.png"/><Relationship Id="rId3" Type="http://schemas.microsoft.com/office/2007/relationships/media" Target="../media/media2.mp4"/><Relationship Id="rId7" Type="http://schemas.microsoft.com/office/2007/relationships/media" Target="../media/media4.mp4"/><Relationship Id="rId12" Type="http://schemas.openxmlformats.org/officeDocument/2006/relationships/image" Target="../media/image2.png"/><Relationship Id="rId2" Type="http://schemas.openxmlformats.org/officeDocument/2006/relationships/video" Target="../media/media1.mp4"/><Relationship Id="rId1" Type="http://schemas.microsoft.com/office/2007/relationships/media" Target="../media/media1.mp4"/><Relationship Id="rId6" Type="http://schemas.openxmlformats.org/officeDocument/2006/relationships/video" Target="../media/media3.mp4"/><Relationship Id="rId11" Type="http://schemas.openxmlformats.org/officeDocument/2006/relationships/image" Target="../media/image1.png"/><Relationship Id="rId5" Type="http://schemas.microsoft.com/office/2007/relationships/media" Target="../media/media3.mp4"/><Relationship Id="rId10" Type="http://schemas.openxmlformats.org/officeDocument/2006/relationships/notesSlide" Target="../notesSlides/notesSlide1.xml"/><Relationship Id="rId4" Type="http://schemas.openxmlformats.org/officeDocument/2006/relationships/video" Target="../media/media2.mp4"/><Relationship Id="rId9" Type="http://schemas.openxmlformats.org/officeDocument/2006/relationships/slideLayout" Target="../slideLayouts/slideLayout1.xml"/><Relationship Id="rId1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kam1m_pao1.0.4_20.0fps_overlaid1.mpeg" descr="pkam1m_pao1.0.4_20.0fps_overlaid1.mpeg">
            <a:hlinkClick r:id="" action="ppaction://media"/>
            <a:extLst>
              <a:ext uri="{FF2B5EF4-FFF2-40B4-BE49-F238E27FC236}">
                <a16:creationId xmlns:a16="http://schemas.microsoft.com/office/drawing/2014/main" id="{AD16E06E-0BB9-304C-70FB-B5349DD5DB7A}"/>
              </a:ext>
            </a:extLst>
          </p:cNvPr>
          <p:cNvPicPr>
            <a:picLocks noChangeAspect="1"/>
          </p:cNvPicPr>
          <p:nvPr>
            <a:videoFile r:link="rId2"/>
            <p:extLst>
              <p:ext uri="{DAA4B4D4-6D71-4841-9C94-3DE7FCFB9230}">
                <p14:media xmlns:p14="http://schemas.microsoft.com/office/powerpoint/2010/main" r:embed="rId1"/>
              </p:ext>
            </p:extLst>
          </p:nvPr>
        </p:nvPicPr>
        <p:blipFill rotWithShape="1">
          <a:blip r:embed="rId11"/>
          <a:srcRect l="6573" t="6597" r="-6574" b="-6598"/>
          <a:stretch/>
        </p:blipFill>
        <p:spPr>
          <a:xfrm>
            <a:off x="430565" y="486893"/>
            <a:ext cx="1721731" cy="1721731"/>
          </a:xfrm>
          <a:prstGeom prst="rect">
            <a:avLst/>
          </a:prstGeom>
        </p:spPr>
      </p:pic>
      <p:sp>
        <p:nvSpPr>
          <p:cNvPr id="5" name="TextBox 4">
            <a:extLst>
              <a:ext uri="{FF2B5EF4-FFF2-40B4-BE49-F238E27FC236}">
                <a16:creationId xmlns:a16="http://schemas.microsoft.com/office/drawing/2014/main" id="{B53EE3D0-5CBC-1FA0-ADC7-F95A8E4E9370}"/>
              </a:ext>
            </a:extLst>
          </p:cNvPr>
          <p:cNvSpPr txBox="1"/>
          <p:nvPr/>
        </p:nvSpPr>
        <p:spPr>
          <a:xfrm>
            <a:off x="754726" y="54528"/>
            <a:ext cx="1154483"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Adhered</a:t>
            </a:r>
          </a:p>
        </p:txBody>
      </p:sp>
      <p:sp>
        <p:nvSpPr>
          <p:cNvPr id="6" name="TextBox 5">
            <a:extLst>
              <a:ext uri="{FF2B5EF4-FFF2-40B4-BE49-F238E27FC236}">
                <a16:creationId xmlns:a16="http://schemas.microsoft.com/office/drawing/2014/main" id="{33167FC3-E2DF-891E-1CE2-A48D2BEEA344}"/>
              </a:ext>
            </a:extLst>
          </p:cNvPr>
          <p:cNvSpPr txBox="1"/>
          <p:nvPr/>
        </p:nvSpPr>
        <p:spPr>
          <a:xfrm>
            <a:off x="6607" y="8057"/>
            <a:ext cx="327334"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a</a:t>
            </a:r>
          </a:p>
        </p:txBody>
      </p:sp>
      <p:pic>
        <p:nvPicPr>
          <p:cNvPr id="7" name="pkam1m_pao1.0.4_20.0fps_overlaid2.mpeg" descr="pkam1m_pao1.0.4_20.0fps_overlaid2.mpeg">
            <a:hlinkClick r:id="" action="ppaction://media"/>
            <a:extLst>
              <a:ext uri="{FF2B5EF4-FFF2-40B4-BE49-F238E27FC236}">
                <a16:creationId xmlns:a16="http://schemas.microsoft.com/office/drawing/2014/main" id="{E76DD2E3-070C-BA2D-DAA0-AF0F7E2DBB63}"/>
              </a:ext>
            </a:extLst>
          </p:cNvPr>
          <p:cNvPicPr>
            <a:picLocks noChangeAspect="1"/>
          </p:cNvPicPr>
          <p:nvPr>
            <a:videoFile r:link="rId4"/>
            <p:extLst>
              <p:ext uri="{DAA4B4D4-6D71-4841-9C94-3DE7FCFB9230}">
                <p14:media xmlns:p14="http://schemas.microsoft.com/office/powerpoint/2010/main" r:embed="rId3"/>
              </p:ext>
            </p:extLst>
          </p:nvPr>
        </p:nvPicPr>
        <p:blipFill>
          <a:blip r:embed="rId12"/>
          <a:stretch>
            <a:fillRect/>
          </a:stretch>
        </p:blipFill>
        <p:spPr>
          <a:xfrm>
            <a:off x="2589545" y="475741"/>
            <a:ext cx="1642122" cy="1617534"/>
          </a:xfrm>
          <a:prstGeom prst="rect">
            <a:avLst/>
          </a:prstGeom>
        </p:spPr>
      </p:pic>
      <p:sp>
        <p:nvSpPr>
          <p:cNvPr id="8" name="TextBox 7">
            <a:extLst>
              <a:ext uri="{FF2B5EF4-FFF2-40B4-BE49-F238E27FC236}">
                <a16:creationId xmlns:a16="http://schemas.microsoft.com/office/drawing/2014/main" id="{A2AB9AF4-4CF0-F52D-F24A-935E87896A87}"/>
              </a:ext>
            </a:extLst>
          </p:cNvPr>
          <p:cNvSpPr txBox="1"/>
          <p:nvPr/>
        </p:nvSpPr>
        <p:spPr>
          <a:xfrm>
            <a:off x="2228509" y="8111"/>
            <a:ext cx="327334"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5A38D8DF-4886-F41F-9508-079A964E18E8}"/>
              </a:ext>
            </a:extLst>
          </p:cNvPr>
          <p:cNvSpPr txBox="1"/>
          <p:nvPr/>
        </p:nvSpPr>
        <p:spPr>
          <a:xfrm>
            <a:off x="2842403" y="54528"/>
            <a:ext cx="1182183" cy="400110"/>
          </a:xfrm>
          <a:prstGeom prst="rect">
            <a:avLst/>
          </a:prstGeom>
          <a:noFill/>
        </p:spPr>
        <p:txBody>
          <a:bodyPr wrap="none" rtlCol="0">
            <a:spAutoFit/>
          </a:bodyPr>
          <a:lstStyle/>
          <a:p>
            <a:pPr algn="ctr"/>
            <a:r>
              <a:rPr lang="en-US" sz="2000" dirty="0">
                <a:latin typeface="Arial" panose="020B0604020202020204" pitchFamily="34" charset="0"/>
                <a:cs typeface="Arial" panose="020B0604020202020204" pitchFamily="34" charset="0"/>
              </a:rPr>
              <a:t>Tethered</a:t>
            </a:r>
          </a:p>
        </p:txBody>
      </p:sp>
      <p:pic>
        <p:nvPicPr>
          <p:cNvPr id="10" name="pkam1m_pao1.0.4_20.0fps_overlaid3.mpeg" descr="pkam1m_pao1.0.4_20.0fps_overlaid3.mpeg">
            <a:hlinkClick r:id="" action="ppaction://media"/>
            <a:extLst>
              <a:ext uri="{FF2B5EF4-FFF2-40B4-BE49-F238E27FC236}">
                <a16:creationId xmlns:a16="http://schemas.microsoft.com/office/drawing/2014/main" id="{AE2F676E-9301-2879-17E5-DBF535E48A06}"/>
              </a:ext>
            </a:extLst>
          </p:cNvPr>
          <p:cNvPicPr>
            <a:picLocks noChangeAspect="1"/>
          </p:cNvPicPr>
          <p:nvPr>
            <a:videoFile r:link="rId6"/>
            <p:extLst>
              <p:ext uri="{DAA4B4D4-6D71-4841-9C94-3DE7FCFB9230}">
                <p14:media xmlns:p14="http://schemas.microsoft.com/office/powerpoint/2010/main" r:embed="rId5"/>
              </p:ext>
            </p:extLst>
          </p:nvPr>
        </p:nvPicPr>
        <p:blipFill>
          <a:blip r:embed="rId13"/>
          <a:stretch>
            <a:fillRect/>
          </a:stretch>
        </p:blipFill>
        <p:spPr>
          <a:xfrm>
            <a:off x="4767166" y="481316"/>
            <a:ext cx="1642122" cy="1617534"/>
          </a:xfrm>
          <a:prstGeom prst="rect">
            <a:avLst/>
          </a:prstGeom>
        </p:spPr>
      </p:pic>
      <p:sp>
        <p:nvSpPr>
          <p:cNvPr id="11" name="TextBox 10">
            <a:extLst>
              <a:ext uri="{FF2B5EF4-FFF2-40B4-BE49-F238E27FC236}">
                <a16:creationId xmlns:a16="http://schemas.microsoft.com/office/drawing/2014/main" id="{A088BA6D-BD61-F58B-7145-66A3E752AF88}"/>
              </a:ext>
            </a:extLst>
          </p:cNvPr>
          <p:cNvSpPr txBox="1"/>
          <p:nvPr/>
        </p:nvSpPr>
        <p:spPr>
          <a:xfrm>
            <a:off x="5109378" y="54528"/>
            <a:ext cx="1011816" cy="400110"/>
          </a:xfrm>
          <a:prstGeom prst="rect">
            <a:avLst/>
          </a:prstGeom>
          <a:noFill/>
        </p:spPr>
        <p:txBody>
          <a:bodyPr wrap="none" rtlCol="0">
            <a:spAutoFit/>
          </a:bodyPr>
          <a:lstStyle/>
          <a:p>
            <a:pPr algn="ctr"/>
            <a:r>
              <a:rPr lang="en-US" sz="2000" dirty="0">
                <a:latin typeface="Arial" panose="020B0604020202020204" pitchFamily="34" charset="0"/>
                <a:cs typeface="Arial" panose="020B0604020202020204" pitchFamily="34" charset="0"/>
              </a:rPr>
              <a:t>Moving</a:t>
            </a:r>
          </a:p>
        </p:txBody>
      </p:sp>
      <p:sp>
        <p:nvSpPr>
          <p:cNvPr id="15" name="TextBox 14">
            <a:extLst>
              <a:ext uri="{FF2B5EF4-FFF2-40B4-BE49-F238E27FC236}">
                <a16:creationId xmlns:a16="http://schemas.microsoft.com/office/drawing/2014/main" id="{8A011965-3377-FB1F-F002-23F93DC52C0D}"/>
              </a:ext>
            </a:extLst>
          </p:cNvPr>
          <p:cNvSpPr txBox="1"/>
          <p:nvPr/>
        </p:nvSpPr>
        <p:spPr>
          <a:xfrm>
            <a:off x="4371567" y="-8418"/>
            <a:ext cx="312906"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c</a:t>
            </a:r>
          </a:p>
        </p:txBody>
      </p:sp>
      <p:pic>
        <p:nvPicPr>
          <p:cNvPr id="16" name="pkam1m_pao1.0.4_20.0fps_overlaid4.mpeg" descr="pkam1m_pao1.0.4_20.0fps_overlaid4.mpeg">
            <a:hlinkClick r:id="" action="ppaction://media"/>
            <a:extLst>
              <a:ext uri="{FF2B5EF4-FFF2-40B4-BE49-F238E27FC236}">
                <a16:creationId xmlns:a16="http://schemas.microsoft.com/office/drawing/2014/main" id="{78424A46-F04A-DF78-5C3D-E727AA81880D}"/>
              </a:ext>
            </a:extLst>
          </p:cNvPr>
          <p:cNvPicPr>
            <a:picLocks noChangeAspect="1"/>
          </p:cNvPicPr>
          <p:nvPr>
            <a:videoFile r:link="rId8"/>
            <p:extLst>
              <p:ext uri="{DAA4B4D4-6D71-4841-9C94-3DE7FCFB9230}">
                <p14:media xmlns:p14="http://schemas.microsoft.com/office/powerpoint/2010/main" r:embed="rId7"/>
              </p:ext>
            </p:extLst>
          </p:nvPr>
        </p:nvPicPr>
        <p:blipFill>
          <a:blip r:embed="rId14"/>
          <a:stretch>
            <a:fillRect/>
          </a:stretch>
        </p:blipFill>
        <p:spPr>
          <a:xfrm>
            <a:off x="6868374" y="461046"/>
            <a:ext cx="1637807" cy="1637807"/>
          </a:xfrm>
          <a:prstGeom prst="rect">
            <a:avLst/>
          </a:prstGeom>
        </p:spPr>
      </p:pic>
      <p:sp>
        <p:nvSpPr>
          <p:cNvPr id="18" name="TextBox 17">
            <a:extLst>
              <a:ext uri="{FF2B5EF4-FFF2-40B4-BE49-F238E27FC236}">
                <a16:creationId xmlns:a16="http://schemas.microsoft.com/office/drawing/2014/main" id="{54F79D6A-9543-7633-1A2F-FA8CC1FF2627}"/>
              </a:ext>
            </a:extLst>
          </p:cNvPr>
          <p:cNvSpPr txBox="1"/>
          <p:nvPr/>
        </p:nvSpPr>
        <p:spPr>
          <a:xfrm>
            <a:off x="6500197" y="-8418"/>
            <a:ext cx="327334" cy="400110"/>
          </a:xfrm>
          <a:prstGeom prst="rect">
            <a:avLst/>
          </a:prstGeom>
          <a:noFill/>
        </p:spPr>
        <p:txBody>
          <a:bodyPr wrap="none" rtlCol="0">
            <a:spAutoFit/>
          </a:bodyPr>
          <a:lstStyle/>
          <a:p>
            <a:r>
              <a:rPr lang="en-US" sz="2000" dirty="0">
                <a:latin typeface="Arial" panose="020B0604020202020204" pitchFamily="34" charset="0"/>
                <a:cs typeface="Arial" panose="020B0604020202020204" pitchFamily="34" charset="0"/>
              </a:rPr>
              <a:t>d</a:t>
            </a:r>
          </a:p>
        </p:txBody>
      </p:sp>
      <p:sp>
        <p:nvSpPr>
          <p:cNvPr id="19" name="TextBox 18">
            <a:extLst>
              <a:ext uri="{FF2B5EF4-FFF2-40B4-BE49-F238E27FC236}">
                <a16:creationId xmlns:a16="http://schemas.microsoft.com/office/drawing/2014/main" id="{97BE781C-A6AA-D27A-94C0-B6B3DD05F4B0}"/>
              </a:ext>
            </a:extLst>
          </p:cNvPr>
          <p:cNvSpPr txBox="1"/>
          <p:nvPr/>
        </p:nvSpPr>
        <p:spPr>
          <a:xfrm>
            <a:off x="6898370" y="54528"/>
            <a:ext cx="1625766" cy="400110"/>
          </a:xfrm>
          <a:prstGeom prst="rect">
            <a:avLst/>
          </a:prstGeom>
          <a:noFill/>
        </p:spPr>
        <p:txBody>
          <a:bodyPr wrap="none" rtlCol="0">
            <a:spAutoFit/>
          </a:bodyPr>
          <a:lstStyle/>
          <a:p>
            <a:pPr algn="ctr"/>
            <a:r>
              <a:rPr lang="en-US" sz="2000" dirty="0">
                <a:latin typeface="Arial" panose="020B0604020202020204" pitchFamily="34" charset="0"/>
                <a:cs typeface="Arial" panose="020B0604020202020204" pitchFamily="34" charset="0"/>
              </a:rPr>
              <a:t>Approaching</a:t>
            </a:r>
          </a:p>
        </p:txBody>
      </p:sp>
      <p:sp>
        <p:nvSpPr>
          <p:cNvPr id="20" name="TextBox 19">
            <a:extLst>
              <a:ext uri="{FF2B5EF4-FFF2-40B4-BE49-F238E27FC236}">
                <a16:creationId xmlns:a16="http://schemas.microsoft.com/office/drawing/2014/main" id="{A5021E5F-A272-4724-B0D9-020635FD43C2}"/>
              </a:ext>
            </a:extLst>
          </p:cNvPr>
          <p:cNvSpPr txBox="1"/>
          <p:nvPr/>
        </p:nvSpPr>
        <p:spPr>
          <a:xfrm>
            <a:off x="110394" y="2164475"/>
            <a:ext cx="8466011" cy="1035925"/>
          </a:xfrm>
          <a:prstGeom prst="rect">
            <a:avLst/>
          </a:prstGeom>
          <a:noFill/>
        </p:spPr>
        <p:txBody>
          <a:bodyPr wrap="square">
            <a:spAutoFit/>
          </a:bodyPr>
          <a:lstStyle/>
          <a:p>
            <a:pPr marL="0" marR="0" algn="just">
              <a:lnSpc>
                <a:spcPct val="150000"/>
              </a:lnSpc>
              <a:spcBef>
                <a:spcPts val="0"/>
              </a:spcBef>
              <a:spcAft>
                <a:spcPts val="800"/>
              </a:spcAft>
            </a:pPr>
            <a:r>
              <a:rPr lang="en-US" sz="1050" b="1" dirty="0">
                <a:effectLst/>
                <a:latin typeface="Times New Roman" panose="02020603050405020304" pitchFamily="18" charset="0"/>
                <a:ea typeface="Calibri" panose="020F0502020204030204" pitchFamily="34" charset="0"/>
                <a:cs typeface="Times New Roman" panose="02020603050405020304" pitchFamily="18" charset="0"/>
              </a:rPr>
              <a:t>Movie S1. Bacterial cell trajectories. </a:t>
            </a:r>
            <a:r>
              <a:rPr lang="en-US" sz="1050" dirty="0">
                <a:effectLst/>
                <a:latin typeface="Times New Roman" panose="02020603050405020304" pitchFamily="18" charset="0"/>
                <a:ea typeface="Calibri" panose="020F0502020204030204" pitchFamily="34" charset="0"/>
                <a:cs typeface="Times New Roman" panose="02020603050405020304" pitchFamily="18" charset="0"/>
              </a:rPr>
              <a:t>Trajectories of </a:t>
            </a:r>
            <a:r>
              <a:rPr lang="en-US" sz="1050" i="1" dirty="0">
                <a:effectLst/>
                <a:latin typeface="Times New Roman" panose="02020603050405020304" pitchFamily="18" charset="0"/>
                <a:ea typeface="Calibri" panose="020F0502020204030204" pitchFamily="34" charset="0"/>
                <a:cs typeface="Times New Roman" panose="02020603050405020304" pitchFamily="18" charset="0"/>
              </a:rPr>
              <a:t>P. aeruginosa</a:t>
            </a:r>
            <a:r>
              <a:rPr lang="en-US" sz="1050" dirty="0">
                <a:effectLst/>
                <a:latin typeface="Times New Roman" panose="02020603050405020304" pitchFamily="18" charset="0"/>
                <a:ea typeface="Calibri" panose="020F0502020204030204" pitchFamily="34" charset="0"/>
                <a:cs typeface="Times New Roman" panose="02020603050405020304" pitchFamily="18" charset="0"/>
              </a:rPr>
              <a:t> PA01 near the lung cell for (</a:t>
            </a:r>
            <a:r>
              <a:rPr lang="en-US" sz="105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050" dirty="0">
                <a:effectLst/>
                <a:latin typeface="Times New Roman" panose="02020603050405020304" pitchFamily="18" charset="0"/>
                <a:ea typeface="Calibri" panose="020F0502020204030204" pitchFamily="34" charset="0"/>
                <a:cs typeface="Times New Roman" panose="02020603050405020304" pitchFamily="18" charset="0"/>
              </a:rPr>
              <a:t>) an attached bacterium, (</a:t>
            </a:r>
            <a:r>
              <a:rPr lang="en-US" sz="105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050" dirty="0">
                <a:effectLst/>
                <a:latin typeface="Times New Roman" panose="02020603050405020304" pitchFamily="18" charset="0"/>
                <a:ea typeface="Calibri" panose="020F0502020204030204" pitchFamily="34" charset="0"/>
                <a:cs typeface="Times New Roman" panose="02020603050405020304" pitchFamily="18" charset="0"/>
              </a:rPr>
              <a:t>) a surface-bound bacterium rotating in the clockwise direction, (</a:t>
            </a:r>
            <a:r>
              <a:rPr lang="en-US" sz="105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050" dirty="0">
                <a:effectLst/>
                <a:latin typeface="Times New Roman" panose="02020603050405020304" pitchFamily="18" charset="0"/>
                <a:ea typeface="Calibri" panose="020F0502020204030204" pitchFamily="34" charset="0"/>
                <a:cs typeface="Times New Roman" panose="02020603050405020304" pitchFamily="18" charset="0"/>
              </a:rPr>
              <a:t>) a bacterium moving on the mammalian cell surface, and (</a:t>
            </a:r>
            <a:r>
              <a:rPr lang="en-US" sz="105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050" dirty="0">
                <a:effectLst/>
                <a:latin typeface="Times New Roman" panose="02020603050405020304" pitchFamily="18" charset="0"/>
                <a:ea typeface="Calibri" panose="020F0502020204030204" pitchFamily="34" charset="0"/>
                <a:cs typeface="Times New Roman" panose="02020603050405020304" pitchFamily="18" charset="0"/>
              </a:rPr>
              <a:t>) a bacterium approaching the H1975 cell and abruptly turning away. Fluorescent images depicting bacterial cells were exclusively featured in the movies to ensure enhanced resolution. The mammalian cells in the movies were depicted in Supplementary Figure S1a-d, delineated by blue circles for clarity.</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3933707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4958" fill="hold"/>
                                        <p:tgtEl>
                                          <p:spTgt spid="4"/>
                                        </p:tgtEl>
                                      </p:cBhvr>
                                    </p:cmd>
                                  </p:childTnLst>
                                </p:cTn>
                              </p:par>
                            </p:childTnLst>
                          </p:cTn>
                        </p:par>
                      </p:childTnLst>
                    </p:cTn>
                  </p:par>
                  <p:par>
                    <p:cTn id="7" fill="hold">
                      <p:stCondLst>
                        <p:cond delay="indefinite"/>
                      </p:stCondLst>
                      <p:childTnLst>
                        <p:par>
                          <p:cTn id="8" fill="hold">
                            <p:stCondLst>
                              <p:cond delay="0"/>
                            </p:stCondLst>
                            <p:childTnLst>
                              <p:par>
                                <p:cTn id="9" presetID="1" presetClass="mediacall" presetSubtype="0" fill="hold" nodeType="clickEffect">
                                  <p:stCondLst>
                                    <p:cond delay="0"/>
                                  </p:stCondLst>
                                  <p:childTnLst>
                                    <p:cmd type="call" cmd="playFrom(0.0)">
                                      <p:cBhvr>
                                        <p:cTn id="10" dur="23750" fill="hold"/>
                                        <p:tgtEl>
                                          <p:spTgt spid="7"/>
                                        </p:tgtEl>
                                      </p:cBhvr>
                                    </p:cmd>
                                  </p:childTnLst>
                                </p:cTn>
                              </p:par>
                            </p:childTnLst>
                          </p:cTn>
                        </p:par>
                      </p:childTnLst>
                    </p:cTn>
                  </p:par>
                  <p:par>
                    <p:cTn id="11" fill="hold">
                      <p:stCondLst>
                        <p:cond delay="indefinite"/>
                      </p:stCondLst>
                      <p:childTnLst>
                        <p:par>
                          <p:cTn id="12" fill="hold">
                            <p:stCondLst>
                              <p:cond delay="0"/>
                            </p:stCondLst>
                            <p:childTnLst>
                              <p:par>
                                <p:cTn id="13" presetID="1" presetClass="mediacall" presetSubtype="0" fill="hold" nodeType="clickEffect">
                                  <p:stCondLst>
                                    <p:cond delay="0"/>
                                  </p:stCondLst>
                                  <p:childTnLst>
                                    <p:cmd type="call" cmd="playFrom(0.0)">
                                      <p:cBhvr>
                                        <p:cTn id="14" dur="5958" fill="hold"/>
                                        <p:tgtEl>
                                          <p:spTgt spid="10"/>
                                        </p:tgtEl>
                                      </p:cBhvr>
                                    </p:cmd>
                                  </p:childTnLst>
                                </p:cTn>
                              </p:par>
                            </p:childTnLst>
                          </p:cTn>
                        </p:par>
                      </p:childTnLst>
                    </p:cTn>
                  </p:par>
                  <p:par>
                    <p:cTn id="15" fill="hold">
                      <p:stCondLst>
                        <p:cond delay="indefinite"/>
                      </p:stCondLst>
                      <p:childTnLst>
                        <p:par>
                          <p:cTn id="16" fill="hold">
                            <p:stCondLst>
                              <p:cond delay="0"/>
                            </p:stCondLst>
                            <p:childTnLst>
                              <p:par>
                                <p:cTn id="17" presetID="1" presetClass="mediacall" presetSubtype="0" fill="hold" nodeType="clickEffect">
                                  <p:stCondLst>
                                    <p:cond delay="0"/>
                                  </p:stCondLst>
                                  <p:childTnLst>
                                    <p:cmd type="call" cmd="playFrom(0.0)">
                                      <p:cBhvr>
                                        <p:cTn id="18" dur="1166" fill="hold"/>
                                        <p:tgtEl>
                                          <p:spTgt spid="16"/>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19" restart="whenNotActive" fill="hold" evtFilter="cancelBubble" nodeType="interactiveSeq">
                <p:stCondLst>
                  <p:cond evt="onClick" delay="0">
                    <p:tgtEl>
                      <p:spTgt spid="4"/>
                    </p:tgtEl>
                  </p:cond>
                </p:stCondLst>
                <p:endSync evt="end" delay="0">
                  <p:rtn val="all"/>
                </p:endSync>
                <p:childTnLst>
                  <p:par>
                    <p:cTn id="20" fill="hold">
                      <p:stCondLst>
                        <p:cond delay="0"/>
                      </p:stCondLst>
                      <p:childTnLst>
                        <p:par>
                          <p:cTn id="21" fill="hold">
                            <p:stCondLst>
                              <p:cond delay="0"/>
                            </p:stCondLst>
                            <p:childTnLst>
                              <p:par>
                                <p:cTn id="22" presetID="2" presetClass="mediacall" presetSubtype="0" fill="hold" nodeType="clickEffect">
                                  <p:stCondLst>
                                    <p:cond delay="0"/>
                                  </p:stCondLst>
                                  <p:childTnLst>
                                    <p:cmd type="call" cmd="togglePause">
                                      <p:cBhvr>
                                        <p:cTn id="23" dur="1" fill="hold"/>
                                        <p:tgtEl>
                                          <p:spTgt spid="4"/>
                                        </p:tgtEl>
                                      </p:cBhvr>
                                    </p:cmd>
                                  </p:childTnLst>
                                </p:cTn>
                              </p:par>
                            </p:childTnLst>
                          </p:cTn>
                        </p:par>
                      </p:childTnLst>
                    </p:cTn>
                  </p:par>
                </p:childTnLst>
              </p:cTn>
              <p:nextCondLst>
                <p:cond evt="onClick" delay="0">
                  <p:tgtEl>
                    <p:spTgt spid="4"/>
                  </p:tgtEl>
                </p:cond>
              </p:nextCondLst>
            </p:seq>
            <p:video>
              <p:cMediaNode vol="80000">
                <p:cTn id="24" fill="hold" display="0">
                  <p:stCondLst>
                    <p:cond delay="indefinite"/>
                  </p:stCondLst>
                </p:cTn>
                <p:tgtEl>
                  <p:spTgt spid="4"/>
                </p:tgtEl>
              </p:cMediaNode>
            </p:video>
            <p:seq concurrent="1" nextAc="seek">
              <p:cTn id="25" restart="whenNotActive" fill="hold" evtFilter="cancelBubble" nodeType="interactiveSeq">
                <p:stCondLst>
                  <p:cond evt="onClick" delay="0">
                    <p:tgtEl>
                      <p:spTgt spid="7"/>
                    </p:tgtEl>
                  </p:cond>
                </p:stCondLst>
                <p:endSync evt="end" delay="0">
                  <p:rtn val="all"/>
                </p:endSync>
                <p:childTnLst>
                  <p:par>
                    <p:cTn id="26" fill="hold">
                      <p:stCondLst>
                        <p:cond delay="0"/>
                      </p:stCondLst>
                      <p:childTnLst>
                        <p:par>
                          <p:cTn id="27" fill="hold">
                            <p:stCondLst>
                              <p:cond delay="0"/>
                            </p:stCondLst>
                            <p:childTnLst>
                              <p:par>
                                <p:cTn id="28" presetID="2" presetClass="mediacall" presetSubtype="0" fill="hold" nodeType="clickEffect">
                                  <p:stCondLst>
                                    <p:cond delay="0"/>
                                  </p:stCondLst>
                                  <p:childTnLst>
                                    <p:cmd type="call" cmd="togglePause">
                                      <p:cBhvr>
                                        <p:cTn id="29" dur="1" fill="hold"/>
                                        <p:tgtEl>
                                          <p:spTgt spid="7"/>
                                        </p:tgtEl>
                                      </p:cBhvr>
                                    </p:cmd>
                                  </p:childTnLst>
                                </p:cTn>
                              </p:par>
                            </p:childTnLst>
                          </p:cTn>
                        </p:par>
                      </p:childTnLst>
                    </p:cTn>
                  </p:par>
                </p:childTnLst>
              </p:cTn>
              <p:nextCondLst>
                <p:cond evt="onClick" delay="0">
                  <p:tgtEl>
                    <p:spTgt spid="7"/>
                  </p:tgtEl>
                </p:cond>
              </p:nextCondLst>
            </p:seq>
            <p:video>
              <p:cMediaNode vol="80000">
                <p:cTn id="30" fill="hold" display="0">
                  <p:stCondLst>
                    <p:cond delay="indefinite"/>
                  </p:stCondLst>
                </p:cTn>
                <p:tgtEl>
                  <p:spTgt spid="7"/>
                </p:tgtEl>
              </p:cMediaNode>
            </p:video>
            <p:seq concurrent="1" nextAc="seek">
              <p:cTn id="31" restart="whenNotActive" fill="hold" evtFilter="cancelBubble" nodeType="interactiveSeq">
                <p:stCondLst>
                  <p:cond evt="onClick" delay="0">
                    <p:tgtEl>
                      <p:spTgt spid="10"/>
                    </p:tgtEl>
                  </p:cond>
                </p:stCondLst>
                <p:endSync evt="end" delay="0">
                  <p:rtn val="all"/>
                </p:endSync>
                <p:childTnLst>
                  <p:par>
                    <p:cTn id="32" fill="hold">
                      <p:stCondLst>
                        <p:cond delay="0"/>
                      </p:stCondLst>
                      <p:childTnLst>
                        <p:par>
                          <p:cTn id="33" fill="hold">
                            <p:stCondLst>
                              <p:cond delay="0"/>
                            </p:stCondLst>
                            <p:childTnLst>
                              <p:par>
                                <p:cTn id="34" presetID="2" presetClass="mediacall" presetSubtype="0" fill="hold" nodeType="clickEffect">
                                  <p:stCondLst>
                                    <p:cond delay="0"/>
                                  </p:stCondLst>
                                  <p:childTnLst>
                                    <p:cmd type="call" cmd="togglePause">
                                      <p:cBhvr>
                                        <p:cTn id="35" dur="1" fill="hold"/>
                                        <p:tgtEl>
                                          <p:spTgt spid="10"/>
                                        </p:tgtEl>
                                      </p:cBhvr>
                                    </p:cmd>
                                  </p:childTnLst>
                                </p:cTn>
                              </p:par>
                            </p:childTnLst>
                          </p:cTn>
                        </p:par>
                      </p:childTnLst>
                    </p:cTn>
                  </p:par>
                </p:childTnLst>
              </p:cTn>
              <p:nextCondLst>
                <p:cond evt="onClick" delay="0">
                  <p:tgtEl>
                    <p:spTgt spid="10"/>
                  </p:tgtEl>
                </p:cond>
              </p:nextCondLst>
            </p:seq>
            <p:video>
              <p:cMediaNode vol="80000">
                <p:cTn id="36" fill="hold" display="0">
                  <p:stCondLst>
                    <p:cond delay="indefinite"/>
                  </p:stCondLst>
                </p:cTn>
                <p:tgtEl>
                  <p:spTgt spid="10"/>
                </p:tgtEl>
              </p:cMediaNode>
            </p:video>
            <p:seq concurrent="1" nextAc="seek">
              <p:cTn id="37" restart="whenNotActive" fill="hold" evtFilter="cancelBubble" nodeType="interactiveSeq">
                <p:stCondLst>
                  <p:cond evt="onClick" delay="0">
                    <p:tgtEl>
                      <p:spTgt spid="16"/>
                    </p:tgtEl>
                  </p:cond>
                </p:stCondLst>
                <p:endSync evt="end" delay="0">
                  <p:rtn val="all"/>
                </p:endSync>
                <p:childTnLst>
                  <p:par>
                    <p:cTn id="38" fill="hold">
                      <p:stCondLst>
                        <p:cond delay="0"/>
                      </p:stCondLst>
                      <p:childTnLst>
                        <p:par>
                          <p:cTn id="39" fill="hold">
                            <p:stCondLst>
                              <p:cond delay="0"/>
                            </p:stCondLst>
                            <p:childTnLst>
                              <p:par>
                                <p:cTn id="40" presetID="2" presetClass="mediacall" presetSubtype="0" fill="hold" nodeType="clickEffect">
                                  <p:stCondLst>
                                    <p:cond delay="0"/>
                                  </p:stCondLst>
                                  <p:childTnLst>
                                    <p:cmd type="call" cmd="togglePause">
                                      <p:cBhvr>
                                        <p:cTn id="41" dur="1" fill="hold"/>
                                        <p:tgtEl>
                                          <p:spTgt spid="16"/>
                                        </p:tgtEl>
                                      </p:cBhvr>
                                    </p:cmd>
                                  </p:childTnLst>
                                </p:cTn>
                              </p:par>
                            </p:childTnLst>
                          </p:cTn>
                        </p:par>
                      </p:childTnLst>
                    </p:cTn>
                  </p:par>
                </p:childTnLst>
              </p:cTn>
              <p:nextCondLst>
                <p:cond evt="onClick" delay="0">
                  <p:tgtEl>
                    <p:spTgt spid="16"/>
                  </p:tgtEl>
                </p:cond>
              </p:nextCondLst>
            </p:seq>
            <p:video>
              <p:cMediaNode vol="80000">
                <p:cTn id="42" fill="hold" display="0">
                  <p:stCondLst>
                    <p:cond delay="indefinite"/>
                  </p:stCondLst>
                </p:cTn>
                <p:tgtEl>
                  <p:spTgt spid="16"/>
                </p:tgtEl>
              </p:cMediaNode>
            </p:video>
          </p:childTnLst>
        </p:cTn>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193</TotalTime>
  <Words>109</Words>
  <Application>Microsoft Office PowerPoint</Application>
  <PresentationFormat>Custom</PresentationFormat>
  <Paragraphs>10</Paragraphs>
  <Slides>1</Slides>
  <Notes>1</Notes>
  <HiddenSlides>0</HiddenSlides>
  <MMClips>4</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hiuddin, Sayed Golam</dc:creator>
  <cp:lastModifiedBy>Sayed Golam Mohiuddin</cp:lastModifiedBy>
  <cp:revision>8</cp:revision>
  <dcterms:created xsi:type="dcterms:W3CDTF">2023-02-17T17:30:07Z</dcterms:created>
  <dcterms:modified xsi:type="dcterms:W3CDTF">2024-10-17T21:03:40Z</dcterms:modified>
</cp:coreProperties>
</file>